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6" r:id="rId2"/>
    <p:sldId id="260" r:id="rId3"/>
    <p:sldId id="257" r:id="rId4"/>
    <p:sldId id="258" r:id="rId5"/>
    <p:sldId id="259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13BB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365" autoAdjust="0"/>
    <p:restoredTop sz="78397"/>
  </p:normalViewPr>
  <p:slideViewPr>
    <p:cSldViewPr snapToGrid="0">
      <p:cViewPr>
        <p:scale>
          <a:sx n="135" d="100"/>
          <a:sy n="135" d="100"/>
        </p:scale>
        <p:origin x="2584" y="6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EF6903-DA99-4549-8927-CBC2BCE19F80}" type="datetimeFigureOut">
              <a:rPr lang="ko-KR" altLang="en-US" smtClean="0"/>
              <a:t>2022. 9. 9.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C2979F-1AB0-42BB-8F22-1282A2E6FE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86944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200" b="1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Table 1.  </a:t>
            </a:r>
            <a:r>
              <a:rPr lang="en-US" altLang="ko-KR" sz="12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st of Antibodies, antibody clones and their corresponding manufacturers used in this study</a:t>
            </a:r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BC2979F-1AB0-42BB-8F22-1282A2E6FEB1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116873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200" b="1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1. Representative gating strategy for flow cytometry.  </a:t>
            </a:r>
            <a:r>
              <a:rPr lang="en-US" altLang="ko-KR" sz="12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 Representative gating strategy of bone marrow cell populations.</a:t>
            </a:r>
            <a:r>
              <a:rPr lang="en-US" altLang="ko-KR" sz="1200" b="1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 Representative gating strategy of spleen cell populations. (C) Representative gating strategy of </a:t>
            </a:r>
            <a:r>
              <a:rPr lang="en-US" altLang="ko-KR" sz="1200" dirty="0" err="1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LN</a:t>
            </a:r>
            <a:r>
              <a:rPr lang="en-US" altLang="ko-KR" sz="12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 populations.</a:t>
            </a:r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BC2979F-1AB0-42BB-8F22-1282A2E6FEB1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776431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sz="1200" b="1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2. TTP deficiency causes expansion of myeloid populations in female as well. </a:t>
            </a:r>
            <a:r>
              <a:rPr lang="en-US" altLang="ko-KR" sz="12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 Flow cytometry analysis of M-MDSC populations in bone marrow and spleen. (B) Flow cytometry analysis of PMN-MDSC populations in bone marrow and spleen. (C) Flow cytometry analysis of macrophages in bone marrow and spleen. One-way analysis of variance with Tukey’s multiple comparisons test and unpaired </a:t>
            </a:r>
            <a:r>
              <a:rPr lang="en-US" altLang="ko-KR" sz="1200" i="1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ko-KR" sz="12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est data are presented as mean ± SEM, *P &lt; 0.05, **P &lt; 0.01, ***P &lt; 0.001, ****P &lt; 0.0001. </a:t>
            </a:r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BC2979F-1AB0-42BB-8F22-1282A2E6FEB1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935251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altLang="ko-KR" sz="1200" b="1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3. TTP deficiency causes expansion of M-MDSCs but no change in inflammatory monocytes. </a:t>
            </a:r>
            <a:r>
              <a:rPr lang="en-US" altLang="ko-KR" sz="12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 Flow cytometry analysis of M-MDSC (CD11c</a:t>
            </a:r>
            <a:r>
              <a:rPr lang="en-US" altLang="ko-KR" sz="1200" baseline="300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ko-KR" sz="12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  <a:r>
              <a:rPr lang="en-US" altLang="ko-KR" sz="1200" baseline="300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12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6G</a:t>
            </a:r>
            <a:r>
              <a:rPr lang="en-US" altLang="ko-KR" sz="1200" baseline="300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en-US" altLang="ko-KR" sz="12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6C</a:t>
            </a:r>
            <a:r>
              <a:rPr lang="en-US" altLang="ko-KR" sz="1200" baseline="300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altLang="ko-KR" sz="12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24</a:t>
            </a:r>
            <a:r>
              <a:rPr lang="en-US" altLang="ko-KR" sz="1200" baseline="300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altLang="ko-KR" sz="12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and inflammatory monocyte (CD11c</a:t>
            </a:r>
            <a:r>
              <a:rPr lang="en-US" altLang="ko-KR" sz="1200" baseline="300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ko-KR" sz="12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  <a:r>
              <a:rPr lang="en-US" altLang="ko-KR" sz="1200" baseline="300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12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6G</a:t>
            </a:r>
            <a:r>
              <a:rPr lang="en-US" altLang="ko-KR" sz="1200" baseline="300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en-US" altLang="ko-KR" sz="12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6C</a:t>
            </a:r>
            <a:r>
              <a:rPr lang="en-US" altLang="ko-KR" sz="1200" baseline="300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altLang="ko-KR" sz="12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24</a:t>
            </a:r>
            <a:r>
              <a:rPr lang="en-US" altLang="ko-KR" sz="1200" baseline="300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en-US" altLang="ko-KR" sz="12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populations in bone marrow. (B) Flow cytometry analysis of M-MDSC and inflammatory monocyte populations in spleen. Unpaired </a:t>
            </a:r>
            <a:r>
              <a:rPr lang="en-US" altLang="ko-KR" sz="1200" i="1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ko-KR" sz="12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est, data are presented as mean ± SEM, *P &lt; 0.05.  </a:t>
            </a:r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BC2979F-1AB0-42BB-8F22-1282A2E6FEB1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916568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4. Quantitative cell cycle phase analysis in single-cell RNA-seq data of bone marrow-derived cells reveals subtle differences in myeloid progenitor populations. </a:t>
            </a:r>
            <a:r>
              <a:rPr lang="en-US" altLang="ko-KR" sz="12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 The percentage of cells in each annotated cluster, plotted as a percentage of total cells sequenced in control, </a:t>
            </a:r>
            <a:r>
              <a:rPr lang="en-US" altLang="ko-KR" sz="1200" dirty="0" err="1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TPKO</a:t>
            </a:r>
            <a:r>
              <a:rPr lang="en-US" altLang="ko-KR" sz="12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and TTPKO mice. (B) Cell Cycle Phase Scoring UMAPs. Cells were scored based on expression of G2/M and S phase marker genes. Cell cycle phase scoring is consistent across the three samples. (C) Phase percentage of myeloid progenitor population.</a:t>
            </a:r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BC2979F-1AB0-42BB-8F22-1282A2E6FEB1}" type="slidenum">
              <a:rPr lang="ko-KR" altLang="en-US" smtClean="0"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404000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dirty="0">
                <a:solidFill>
                  <a:srgbClr val="313BB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5: M-MDSC egress genes are weakly expressed in mesenchymal stem cell populations. </a:t>
            </a:r>
            <a:r>
              <a:rPr lang="en-US" sz="1200" dirty="0" err="1">
                <a:solidFill>
                  <a:srgbClr val="313BB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tplot</a:t>
            </a:r>
            <a:r>
              <a:rPr lang="en-US" sz="1200" dirty="0">
                <a:solidFill>
                  <a:srgbClr val="313BB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howing the expression of genes that contribute to M-MDSC mobilization for all cell types within the bone marrow of control, TTP KO, and </a:t>
            </a:r>
            <a:r>
              <a:rPr lang="en-US" sz="1200" dirty="0" err="1">
                <a:solidFill>
                  <a:srgbClr val="313BB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TPKO</a:t>
            </a:r>
            <a:r>
              <a:rPr lang="en-US" sz="1200" dirty="0">
                <a:solidFill>
                  <a:srgbClr val="313BB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A low number of cells in the Mesenchymal Stem Cell cluster, highlighted with a red box, expressing these genes (&lt;25%) at low levels of all egress-associated  genes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BC2979F-1AB0-42BB-8F22-1282A2E6FEB1}" type="slidenum">
              <a:rPr lang="ko-KR" altLang="en-US" smtClean="0"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51707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1F57E1-F874-4AA5-A224-E54714B439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EC769C0-0995-402C-B9B6-45DF3579B04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D8D570-1AF7-48AF-B961-FF48E6A65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1F55E-5C04-4C62-9178-C2F21E991345}" type="datetimeFigureOut">
              <a:rPr lang="en-US" smtClean="0"/>
              <a:t>9/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88A4DE-1E4E-4B06-8E87-A2B05DB82D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8D0CCE-2B6D-444C-A99C-4AB83EC8B8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CF290-6021-42B3-9F24-EA09B4B2C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86364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B5F133-D180-49F9-9584-32D60B78F4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F3EAF71-AC4C-4E98-847F-FE7761F656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E7367F-E7E3-4C24-981B-25C89E361C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1F55E-5C04-4C62-9178-C2F21E991345}" type="datetimeFigureOut">
              <a:rPr lang="en-US" smtClean="0"/>
              <a:t>9/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549479-551E-495E-B3EE-F16B557B8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DBD16E-6556-4090-B157-DD9806B0EF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CF290-6021-42B3-9F24-EA09B4B2C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0426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F71FD78-4BB6-499E-B1AD-58CF9676F17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DE704D4-CD59-4036-A3CC-AFF4A5F237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5EBFEC-B9D1-478A-8A7E-757E37C93E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1F55E-5C04-4C62-9178-C2F21E991345}" type="datetimeFigureOut">
              <a:rPr lang="en-US" smtClean="0"/>
              <a:t>9/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3EAE61-E329-4816-8A24-24EF00192E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A4F8B9-A191-47A1-9C5D-033011FF8C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CF290-6021-42B3-9F24-EA09B4B2C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806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C6435A-938C-4329-B1CF-B01D591125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F83358-38C2-4911-80D0-EA022C9E80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DED182-BFB3-42C3-A175-8B7EE73525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1F55E-5C04-4C62-9178-C2F21E991345}" type="datetimeFigureOut">
              <a:rPr lang="en-US" smtClean="0"/>
              <a:t>9/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2A5B47-37F6-47A2-892C-D9683C34B2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08FE5E-8069-4194-B67A-DF90352E37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CF290-6021-42B3-9F24-EA09B4B2C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1138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DDAC08-548E-42E8-ABA7-6AD631DCDC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6E23E2-2485-455A-8C05-A5CDD287B6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7860D5-5D70-44E0-B90D-0FB87B0643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1F55E-5C04-4C62-9178-C2F21E991345}" type="datetimeFigureOut">
              <a:rPr lang="en-US" smtClean="0"/>
              <a:t>9/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264C20-53BB-4E58-8018-80919CC2E1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AB45FB-103B-433B-80DD-3BE380F1BA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CF290-6021-42B3-9F24-EA09B4B2C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563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BF8366-0291-4781-9109-A79BAEEF2E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27D5CB-2E44-4B54-BE3E-EF930C3A97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483594-C903-4F77-95E3-6F0EFF6026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C44850-D45B-46FE-B6AD-87D311F992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1F55E-5C04-4C62-9178-C2F21E991345}" type="datetimeFigureOut">
              <a:rPr lang="en-US" smtClean="0"/>
              <a:t>9/9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F0DAE07-0BD3-4481-A21F-5624A1FD79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4920BE-0AD8-40C6-A039-84E0274B4E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CF290-6021-42B3-9F24-EA09B4B2C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1238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A5D1C6-0127-447D-8A72-DBCE4A6D4A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102227-9F18-4B8B-89F4-0496E01E61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391FAC-FC6F-403B-ACE4-6689217BEB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B64F320-95B1-4F83-8234-CEBBBE5DB30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011C652-1A63-45AB-B013-D57EF5F5E87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1B6FE2E-D7C3-4B54-8484-9AE992CF67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1F55E-5C04-4C62-9178-C2F21E991345}" type="datetimeFigureOut">
              <a:rPr lang="en-US" smtClean="0"/>
              <a:t>9/9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ABF39E5-841F-4C53-83F4-C7F6125E79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3B594D9-CF24-459D-9A70-200F3EE28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CF290-6021-42B3-9F24-EA09B4B2C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27680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C3604E-DF81-465D-B8D4-664227AC18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7C4CEBB-114B-42BC-9522-0C18D59FFE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1F55E-5C04-4C62-9178-C2F21E991345}" type="datetimeFigureOut">
              <a:rPr lang="en-US" smtClean="0"/>
              <a:t>9/9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A0315BF-C48A-40BC-B029-0CBF336DFA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898A952-5964-47E3-8102-681428FF25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CF290-6021-42B3-9F24-EA09B4B2C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9939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CC63F45-A4A7-4C65-8696-7AF45CCF90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1F55E-5C04-4C62-9178-C2F21E991345}" type="datetimeFigureOut">
              <a:rPr lang="en-US" smtClean="0"/>
              <a:t>9/9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E214E20-D373-4B7E-B670-201517F844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B41D465-B862-4A5D-AA1D-4915878607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CF290-6021-42B3-9F24-EA09B4B2C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8198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ADC9EA-8E1C-4700-A858-04305AA955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4329B1-5E6D-4088-BF5D-508FDB30B9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552F501-06A4-4B0A-8E49-D890E82E04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F2E83F-D96A-413B-A398-C049CBD346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1F55E-5C04-4C62-9178-C2F21E991345}" type="datetimeFigureOut">
              <a:rPr lang="en-US" smtClean="0"/>
              <a:t>9/9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1C3816-52ED-4D86-B86D-998ECD5E92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A3510E-9DC1-407B-9331-2C8331BC0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CF290-6021-42B3-9F24-EA09B4B2C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9241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6B2F82-EF5C-4343-9949-25343F208D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E89DD85-033E-418B-940C-46E7E1F15FF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C8DBDB-4069-44A6-9A63-B6448DBD56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C65E7D-FCF9-48C4-B1C8-C8B2AA73C9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1F55E-5C04-4C62-9178-C2F21E991345}" type="datetimeFigureOut">
              <a:rPr lang="en-US" smtClean="0"/>
              <a:t>9/9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F6943E-509F-4818-8B15-744393CE99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A78461-3D19-4C51-BF99-44AC5EB30C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CF290-6021-42B3-9F24-EA09B4B2C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23575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DCA14FA-55C1-4FFB-B623-581B97C3BA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60CB59-C043-4C44-97BD-55313EDDF6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F2A85B-4C29-49D0-B08B-5E3A44FA8F5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11F55E-5C04-4C62-9178-C2F21E991345}" type="datetimeFigureOut">
              <a:rPr lang="en-US" smtClean="0"/>
              <a:t>9/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528155-E2EA-4310-AD4B-99EC4069826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EAC2FB-BC71-4771-93F4-D5F55268334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ACF290-6021-42B3-9F24-EA09B4B2C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6088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3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13" Type="http://schemas.openxmlformats.org/officeDocument/2006/relationships/image" Target="../media/image21.png"/><Relationship Id="rId3" Type="http://schemas.openxmlformats.org/officeDocument/2006/relationships/oleObject" Target="../embeddings/oleObject4.bin"/><Relationship Id="rId7" Type="http://schemas.openxmlformats.org/officeDocument/2006/relationships/oleObject" Target="../embeddings/oleObject6.bin"/><Relationship Id="rId12" Type="http://schemas.openxmlformats.org/officeDocument/2006/relationships/image" Target="../media/image20.emf"/><Relationship Id="rId17" Type="http://schemas.openxmlformats.org/officeDocument/2006/relationships/image" Target="../media/image24.pn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2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emf"/><Relationship Id="rId11" Type="http://schemas.openxmlformats.org/officeDocument/2006/relationships/oleObject" Target="../embeddings/oleObject8.bin"/><Relationship Id="rId5" Type="http://schemas.openxmlformats.org/officeDocument/2006/relationships/oleObject" Target="../embeddings/oleObject5.bin"/><Relationship Id="rId15" Type="http://schemas.openxmlformats.org/officeDocument/2006/relationships/oleObject" Target="../embeddings/oleObject9.bin"/><Relationship Id="rId10" Type="http://schemas.openxmlformats.org/officeDocument/2006/relationships/image" Target="../media/image19.emf"/><Relationship Id="rId4" Type="http://schemas.openxmlformats.org/officeDocument/2006/relationships/image" Target="../media/image16.emf"/><Relationship Id="rId9" Type="http://schemas.openxmlformats.org/officeDocument/2006/relationships/oleObject" Target="../embeddings/oleObject7.bin"/><Relationship Id="rId14" Type="http://schemas.openxmlformats.org/officeDocument/2006/relationships/image" Target="../media/image2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emf"/><Relationship Id="rId5" Type="http://schemas.openxmlformats.org/officeDocument/2006/relationships/image" Target="../media/image26.emf"/><Relationship Id="rId4" Type="http://schemas.openxmlformats.org/officeDocument/2006/relationships/oleObject" Target="../embeddings/oleObject10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A4B68D6D-8537-456A-B7B9-BAE3FF65D0E2}"/>
              </a:ext>
            </a:extLst>
          </p:cNvPr>
          <p:cNvSpPr txBox="1">
            <a:spLocks noGrp="1" noRot="1" noMove="1" noResize="1" noEditPoints="1" noAdjustHandles="1" noChangeArrowheads="1" noChangeShapeType="1"/>
          </p:cNvSpPr>
          <p:nvPr/>
        </p:nvSpPr>
        <p:spPr>
          <a:xfrm>
            <a:off x="0" y="1"/>
            <a:ext cx="4866968" cy="36596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45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endParaRPr lang="en-US" sz="2000" dirty="0">
              <a:solidFill>
                <a:srgbClr val="00009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AD18D09E-AB76-4095-B602-939089EEF85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65131044"/>
              </p:ext>
            </p:extLst>
          </p:nvPr>
        </p:nvGraphicFramePr>
        <p:xfrm>
          <a:off x="0" y="619598"/>
          <a:ext cx="12192000" cy="623840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23925">
                  <a:extLst>
                    <a:ext uri="{9D8B030D-6E8A-4147-A177-3AD203B41FA5}">
                      <a16:colId xmlns:a16="http://schemas.microsoft.com/office/drawing/2014/main" val="363961106"/>
                    </a:ext>
                  </a:extLst>
                </a:gridCol>
                <a:gridCol w="1304925">
                  <a:extLst>
                    <a:ext uri="{9D8B030D-6E8A-4147-A177-3AD203B41FA5}">
                      <a16:colId xmlns:a16="http://schemas.microsoft.com/office/drawing/2014/main" val="4191771325"/>
                    </a:ext>
                  </a:extLst>
                </a:gridCol>
                <a:gridCol w="1562100">
                  <a:extLst>
                    <a:ext uri="{9D8B030D-6E8A-4147-A177-3AD203B41FA5}">
                      <a16:colId xmlns:a16="http://schemas.microsoft.com/office/drawing/2014/main" val="552300481"/>
                    </a:ext>
                  </a:extLst>
                </a:gridCol>
                <a:gridCol w="1504950">
                  <a:extLst>
                    <a:ext uri="{9D8B030D-6E8A-4147-A177-3AD203B41FA5}">
                      <a16:colId xmlns:a16="http://schemas.microsoft.com/office/drawing/2014/main" val="340803748"/>
                    </a:ext>
                  </a:extLst>
                </a:gridCol>
                <a:gridCol w="971550">
                  <a:extLst>
                    <a:ext uri="{9D8B030D-6E8A-4147-A177-3AD203B41FA5}">
                      <a16:colId xmlns:a16="http://schemas.microsoft.com/office/drawing/2014/main" val="28882743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425234235"/>
                    </a:ext>
                  </a:extLst>
                </a:gridCol>
                <a:gridCol w="1400175">
                  <a:extLst>
                    <a:ext uri="{9D8B030D-6E8A-4147-A177-3AD203B41FA5}">
                      <a16:colId xmlns:a16="http://schemas.microsoft.com/office/drawing/2014/main" val="1219272757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val="2768258103"/>
                    </a:ext>
                  </a:extLst>
                </a:gridCol>
                <a:gridCol w="1514475">
                  <a:extLst>
                    <a:ext uri="{9D8B030D-6E8A-4147-A177-3AD203B41FA5}">
                      <a16:colId xmlns:a16="http://schemas.microsoft.com/office/drawing/2014/main" val="512492107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val="2597264570"/>
                    </a:ext>
                  </a:extLst>
                </a:gridCol>
              </a:tblGrid>
              <a:tr h="524231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Antige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Fluo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Clo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Manufactur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Catalog Number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Antige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Fluo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Clo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Manufactur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Catalog Number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74504992"/>
                  </a:ext>
                </a:extLst>
              </a:tr>
              <a:tr h="509409">
                <a:tc>
                  <a:txBody>
                    <a:bodyPr/>
                    <a:lstStyle/>
                    <a:p>
                      <a:r>
                        <a:rPr lang="en-US" sz="1400" dirty="0"/>
                        <a:t>CD11b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/>
                        <a:t>AP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/>
                        <a:t>M1/70 15.11.5</a:t>
                      </a:r>
                    </a:p>
                  </a:txBody>
                  <a:tcPr/>
                </a:tc>
                <a:tc rowSpan="1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400" dirty="0"/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400" dirty="0"/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400" dirty="0"/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400" dirty="0"/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400" dirty="0"/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400" dirty="0"/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400" dirty="0"/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400" dirty="0"/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400" dirty="0"/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err="1"/>
                        <a:t>Miltenyi</a:t>
                      </a:r>
                      <a:r>
                        <a:rPr lang="en-US" sz="1400" dirty="0"/>
                        <a:t> </a:t>
                      </a:r>
                      <a:r>
                        <a:rPr lang="en-US" sz="1400" dirty="0" err="1"/>
                        <a:t>Biotec</a:t>
                      </a:r>
                      <a:endParaRPr lang="en-US" sz="1400" dirty="0"/>
                    </a:p>
                    <a:p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130-113-231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CD16/3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err="1"/>
                        <a:t>PerCP</a:t>
                      </a:r>
                      <a:r>
                        <a:rPr lang="en-US" sz="1400" dirty="0"/>
                        <a:t> Cy5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93</a:t>
                      </a:r>
                    </a:p>
                  </a:txBody>
                  <a:tcPr/>
                </a:tc>
                <a:tc rowSpan="11"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  <a:p>
                      <a:pPr algn="ctr"/>
                      <a:endParaRPr lang="en-US" sz="1400" dirty="0"/>
                    </a:p>
                    <a:p>
                      <a:pPr algn="ctr"/>
                      <a:endParaRPr lang="en-US" sz="1400" dirty="0"/>
                    </a:p>
                    <a:p>
                      <a:pPr algn="ctr"/>
                      <a:endParaRPr lang="en-US" sz="1400" dirty="0"/>
                    </a:p>
                    <a:p>
                      <a:pPr algn="ctr"/>
                      <a:endParaRPr lang="en-US" sz="1400" dirty="0"/>
                    </a:p>
                    <a:p>
                      <a:pPr algn="ctr"/>
                      <a:endParaRPr lang="en-US" sz="1400" dirty="0"/>
                    </a:p>
                    <a:p>
                      <a:pPr algn="ctr"/>
                      <a:endParaRPr lang="en-US" sz="1400" dirty="0"/>
                    </a:p>
                    <a:p>
                      <a:pPr algn="ctr"/>
                      <a:endParaRPr lang="en-US" sz="1400" dirty="0"/>
                    </a:p>
                    <a:p>
                      <a:pPr algn="ctr"/>
                      <a:endParaRPr lang="en-US" sz="1400" dirty="0"/>
                    </a:p>
                    <a:p>
                      <a:pPr algn="ctr"/>
                      <a:endParaRPr lang="en-US" sz="1400" dirty="0"/>
                    </a:p>
                    <a:p>
                      <a:pPr algn="ctr"/>
                      <a:r>
                        <a:rPr lang="en-US" sz="1400" dirty="0" err="1"/>
                        <a:t>Biolegend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0132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32840630"/>
                  </a:ext>
                </a:extLst>
              </a:tr>
              <a:tr h="509409">
                <a:tc>
                  <a:txBody>
                    <a:bodyPr/>
                    <a:lstStyle/>
                    <a:p>
                      <a:r>
                        <a:rPr lang="en-US" sz="1400" dirty="0"/>
                        <a:t>Ly6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FIT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REA 796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130-111-915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err="1"/>
                        <a:t>cKit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APC/Fire 75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2B8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0583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51334226"/>
                  </a:ext>
                </a:extLst>
              </a:tr>
              <a:tr h="631616">
                <a:tc>
                  <a:txBody>
                    <a:bodyPr/>
                    <a:lstStyle/>
                    <a:p>
                      <a:r>
                        <a:rPr lang="en-US" sz="1400" dirty="0"/>
                        <a:t>Ly6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P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REA 526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130-102-392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CD15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BV 60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TC15-12F12.2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1592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76420250"/>
                  </a:ext>
                </a:extLst>
              </a:tr>
              <a:tr h="509409">
                <a:tc>
                  <a:txBody>
                    <a:bodyPr/>
                    <a:lstStyle/>
                    <a:p>
                      <a:r>
                        <a:rPr lang="en-US" sz="1400" dirty="0"/>
                        <a:t>F4/8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PE-Vio77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REA 126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130-118-459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Ly6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Ax7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HK1.4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2802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97744857"/>
                  </a:ext>
                </a:extLst>
              </a:tr>
              <a:tr h="509409">
                <a:tc>
                  <a:txBody>
                    <a:bodyPr/>
                    <a:lstStyle/>
                    <a:p>
                      <a:r>
                        <a:rPr lang="en-US" sz="1400" dirty="0"/>
                        <a:t>CD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 err="1"/>
                        <a:t>Vioblue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REA 604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130-118-696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Sca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PECy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D7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0811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83808194"/>
                  </a:ext>
                </a:extLst>
              </a:tr>
              <a:tr h="471720">
                <a:tc>
                  <a:txBody>
                    <a:bodyPr/>
                    <a:lstStyle/>
                    <a:p>
                      <a:r>
                        <a:rPr lang="en-US" sz="1400" dirty="0"/>
                        <a:t>CD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PE-Vio77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7D4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130-120-815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Flit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P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A2F10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3530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83259661"/>
                  </a:ext>
                </a:extLst>
              </a:tr>
              <a:tr h="509409">
                <a:tc>
                  <a:txBody>
                    <a:bodyPr/>
                    <a:lstStyle/>
                    <a:p>
                      <a:r>
                        <a:rPr lang="en-US" sz="1400" dirty="0"/>
                        <a:t>Foxp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P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REA 788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130-111-678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CD11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AP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AFS98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3550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4169772"/>
                  </a:ext>
                </a:extLst>
              </a:tr>
              <a:tr h="509409">
                <a:tc>
                  <a:txBody>
                    <a:bodyPr/>
                    <a:lstStyle/>
                    <a:p>
                      <a:r>
                        <a:rPr lang="en-US" sz="1400" dirty="0"/>
                        <a:t>CD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APC-Vio77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REA601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130-120-806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rowSpan="3">
                  <a:txBody>
                    <a:bodyPr/>
                    <a:lstStyle/>
                    <a:p>
                      <a:endParaRPr lang="en-US" sz="1400" dirty="0"/>
                    </a:p>
                    <a:p>
                      <a:endParaRPr lang="en-US" sz="1400" dirty="0"/>
                    </a:p>
                    <a:p>
                      <a:r>
                        <a:rPr lang="en-US" sz="1400" dirty="0"/>
                        <a:t>Lineag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rowSpan="3">
                  <a:txBody>
                    <a:bodyPr/>
                    <a:lstStyle/>
                    <a:p>
                      <a:endParaRPr lang="en-US" sz="1400" dirty="0"/>
                    </a:p>
                    <a:p>
                      <a:endParaRPr lang="en-US" sz="1400" dirty="0"/>
                    </a:p>
                    <a:p>
                      <a:r>
                        <a:rPr lang="en-US" sz="1400" dirty="0" err="1"/>
                        <a:t>PacBlue</a:t>
                      </a:r>
                      <a:endParaRPr lang="en-US" sz="1400" dirty="0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/>
                        <a:t>17A2; RB68C5; RA36B2; Ter119; M1/70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endParaRPr lang="en-US" sz="1400" dirty="0"/>
                    </a:p>
                    <a:p>
                      <a:endParaRPr lang="en-US" sz="1400" dirty="0"/>
                    </a:p>
                    <a:p>
                      <a:r>
                        <a:rPr lang="en-US" sz="1400" dirty="0"/>
                        <a:t>13331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58542308"/>
                  </a:ext>
                </a:extLst>
              </a:tr>
              <a:tr h="509409">
                <a:tc>
                  <a:txBody>
                    <a:bodyPr/>
                    <a:lstStyle/>
                    <a:p>
                      <a:r>
                        <a:rPr lang="en-US" sz="1400" dirty="0"/>
                        <a:t>CD11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AP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REA 754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130-110-702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0828790"/>
                  </a:ext>
                </a:extLst>
              </a:tr>
              <a:tr h="509409">
                <a:tc>
                  <a:txBody>
                    <a:bodyPr/>
                    <a:lstStyle/>
                    <a:p>
                      <a:r>
                        <a:rPr lang="en-US" sz="1400" dirty="0"/>
                        <a:t>CD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FIT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6D5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130-119-800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02400219"/>
                  </a:ext>
                </a:extLst>
              </a:tr>
              <a:tr h="535563">
                <a:tc>
                  <a:txBody>
                    <a:bodyPr/>
                    <a:lstStyle/>
                    <a:p>
                      <a:r>
                        <a:rPr lang="en-US" sz="1400" dirty="0"/>
                        <a:t>NK1.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P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PK136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130-116-504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CD10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PECy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/>
                        <a:t>MJ7/18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2042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9472082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3F567E18-CC04-7E87-5B5E-A7A8C4A95E47}"/>
              </a:ext>
            </a:extLst>
          </p:cNvPr>
          <p:cNvSpPr txBox="1"/>
          <p:nvPr/>
        </p:nvSpPr>
        <p:spPr>
          <a:xfrm>
            <a:off x="0" y="-26733"/>
            <a:ext cx="1219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Table 1.  </a:t>
            </a:r>
            <a:r>
              <a:rPr lang="en-US" altLang="ko-KR" sz="14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st of Antibodies, antibody clones and their corresponding manufacturers used in this study</a:t>
            </a:r>
          </a:p>
        </p:txBody>
      </p:sp>
    </p:spTree>
    <p:extLst>
      <p:ext uri="{BB962C8B-B14F-4D97-AF65-F5344CB8AC3E}">
        <p14:creationId xmlns:p14="http://schemas.microsoft.com/office/powerpoint/2010/main" val="4972620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BACC202-0608-C5F9-0A8A-38546EE7BB76}"/>
              </a:ext>
            </a:extLst>
          </p:cNvPr>
          <p:cNvSpPr txBox="1"/>
          <p:nvPr/>
        </p:nvSpPr>
        <p:spPr>
          <a:xfrm>
            <a:off x="-19871" y="-58690"/>
            <a:ext cx="301083" cy="4566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367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4E10669-585C-7329-9BB9-DF134BABFCF0}"/>
              </a:ext>
            </a:extLst>
          </p:cNvPr>
          <p:cNvSpPr txBox="1"/>
          <p:nvPr/>
        </p:nvSpPr>
        <p:spPr>
          <a:xfrm>
            <a:off x="0" y="1964575"/>
            <a:ext cx="301083" cy="4566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367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D2CD7FA-803A-93E3-FB63-431E7D97B42D}"/>
              </a:ext>
            </a:extLst>
          </p:cNvPr>
          <p:cNvSpPr txBox="1"/>
          <p:nvPr/>
        </p:nvSpPr>
        <p:spPr>
          <a:xfrm>
            <a:off x="-1" y="3985065"/>
            <a:ext cx="301083" cy="4566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367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6" name="Rectangle 2">
            <a:extLst>
              <a:ext uri="{FF2B5EF4-FFF2-40B4-BE49-F238E27FC236}">
                <a16:creationId xmlns:a16="http://schemas.microsoft.com/office/drawing/2014/main" id="{DD153B67-47DB-D21C-AB8F-AB5B3C68C1E0}"/>
              </a:ext>
            </a:extLst>
          </p:cNvPr>
          <p:cNvSpPr txBox="1">
            <a:spLocks noChangeArrowheads="1"/>
          </p:cNvSpPr>
          <p:nvPr/>
        </p:nvSpPr>
        <p:spPr>
          <a:xfrm>
            <a:off x="-31449" y="6127506"/>
            <a:ext cx="12208932" cy="86686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45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1. Representative gating strategy for flow cytometry. </a:t>
            </a:r>
            <a:r>
              <a:rPr lang="en-US" altLang="ko-KR" sz="14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 Representative gating strategy of bone marrow cell populations.</a:t>
            </a:r>
            <a:r>
              <a:rPr lang="en-US" altLang="ko-KR" sz="1400" b="1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 Representative gating strategy of spleen cell populations. (C) Representative gating strategy of </a:t>
            </a:r>
            <a:r>
              <a:rPr lang="en-US" altLang="ko-KR" sz="1400" dirty="0" err="1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LN</a:t>
            </a:r>
            <a:r>
              <a:rPr lang="en-US" altLang="ko-KR" sz="14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 populations.</a:t>
            </a:r>
            <a:endParaRPr lang="en-US" sz="1400" dirty="0">
              <a:solidFill>
                <a:srgbClr val="00009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8" name="그룹 107">
            <a:extLst>
              <a:ext uri="{FF2B5EF4-FFF2-40B4-BE49-F238E27FC236}">
                <a16:creationId xmlns:a16="http://schemas.microsoft.com/office/drawing/2014/main" id="{0E3A3E36-7E9E-A3C5-AF7E-850E95EC480B}"/>
              </a:ext>
            </a:extLst>
          </p:cNvPr>
          <p:cNvGrpSpPr/>
          <p:nvPr/>
        </p:nvGrpSpPr>
        <p:grpSpPr>
          <a:xfrm>
            <a:off x="553854" y="4312424"/>
            <a:ext cx="9720394" cy="2029085"/>
            <a:chOff x="335877" y="2331544"/>
            <a:chExt cx="9720394" cy="2029085"/>
          </a:xfrm>
        </p:grpSpPr>
        <p:pic>
          <p:nvPicPr>
            <p:cNvPr id="53" name="그림 52">
              <a:extLst>
                <a:ext uri="{FF2B5EF4-FFF2-40B4-BE49-F238E27FC236}">
                  <a16:creationId xmlns:a16="http://schemas.microsoft.com/office/drawing/2014/main" id="{2BDE4632-BB17-0198-A82C-2EDB94FEB16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37265" y="2334882"/>
              <a:ext cx="1882431" cy="1825215"/>
            </a:xfrm>
            <a:prstGeom prst="rect">
              <a:avLst/>
            </a:prstGeom>
          </p:spPr>
        </p:pic>
        <p:pic>
          <p:nvPicPr>
            <p:cNvPr id="54" name="그림 53">
              <a:extLst>
                <a:ext uri="{FF2B5EF4-FFF2-40B4-BE49-F238E27FC236}">
                  <a16:creationId xmlns:a16="http://schemas.microsoft.com/office/drawing/2014/main" id="{53152BE2-42B1-6554-6AD7-26D23EF1327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794456" y="2334882"/>
              <a:ext cx="1882431" cy="1825214"/>
            </a:xfrm>
            <a:prstGeom prst="rect">
              <a:avLst/>
            </a:prstGeom>
          </p:spPr>
        </p:pic>
        <p:pic>
          <p:nvPicPr>
            <p:cNvPr id="57" name="그림 56">
              <a:extLst>
                <a:ext uri="{FF2B5EF4-FFF2-40B4-BE49-F238E27FC236}">
                  <a16:creationId xmlns:a16="http://schemas.microsoft.com/office/drawing/2014/main" id="{B45E721B-7E4D-B762-0C2B-0261A902659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213092" y="2334882"/>
              <a:ext cx="1882432" cy="1864894"/>
            </a:xfrm>
            <a:prstGeom prst="rect">
              <a:avLst/>
            </a:prstGeom>
          </p:spPr>
        </p:pic>
        <p:pic>
          <p:nvPicPr>
            <p:cNvPr id="58" name="그림 57">
              <a:extLst>
                <a:ext uri="{FF2B5EF4-FFF2-40B4-BE49-F238E27FC236}">
                  <a16:creationId xmlns:a16="http://schemas.microsoft.com/office/drawing/2014/main" id="{C2E19664-8BDB-8B8C-21B3-324D28FD4EE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631729" y="2331544"/>
              <a:ext cx="1923355" cy="1864894"/>
            </a:xfrm>
            <a:prstGeom prst="rect">
              <a:avLst/>
            </a:prstGeom>
          </p:spPr>
        </p:pic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1C85E9E5-9B22-5035-76F1-C8B18E405033}"/>
                </a:ext>
              </a:extLst>
            </p:cNvPr>
            <p:cNvSpPr txBox="1"/>
            <p:nvPr/>
          </p:nvSpPr>
          <p:spPr>
            <a:xfrm>
              <a:off x="1892035" y="4063093"/>
              <a:ext cx="4053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FSC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A32FE6B0-BE06-110D-31B4-10E3DE3034F0}"/>
                </a:ext>
              </a:extLst>
            </p:cNvPr>
            <p:cNvSpPr txBox="1"/>
            <p:nvPr/>
          </p:nvSpPr>
          <p:spPr>
            <a:xfrm rot="16200000">
              <a:off x="270635" y="2454259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SSC</a:t>
              </a:r>
            </a:p>
          </p:txBody>
        </p:sp>
        <p:cxnSp>
          <p:nvCxnSpPr>
            <p:cNvPr id="65" name="Straight Arrow Connector 32">
              <a:extLst>
                <a:ext uri="{FF2B5EF4-FFF2-40B4-BE49-F238E27FC236}">
                  <a16:creationId xmlns:a16="http://schemas.microsoft.com/office/drawing/2014/main" id="{0DEA1726-32CD-2D57-21FD-4B4A609822D4}"/>
                </a:ext>
              </a:extLst>
            </p:cNvPr>
            <p:cNvCxnSpPr/>
            <p:nvPr/>
          </p:nvCxnSpPr>
          <p:spPr>
            <a:xfrm flipV="1">
              <a:off x="592945" y="2411642"/>
              <a:ext cx="3075" cy="142705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Arrow Connector 33">
              <a:extLst>
                <a:ext uri="{FF2B5EF4-FFF2-40B4-BE49-F238E27FC236}">
                  <a16:creationId xmlns:a16="http://schemas.microsoft.com/office/drawing/2014/main" id="{97590573-3ADF-BC16-FA57-71B63CF8F75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15773" y="4046260"/>
              <a:ext cx="1447681" cy="13934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FBE01EA1-781A-06AF-56A7-943D70545F4C}"/>
                </a:ext>
              </a:extLst>
            </p:cNvPr>
            <p:cNvSpPr txBox="1"/>
            <p:nvPr/>
          </p:nvSpPr>
          <p:spPr>
            <a:xfrm rot="16200000">
              <a:off x="2644125" y="2470784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SSC</a:t>
              </a:r>
            </a:p>
          </p:txBody>
        </p:sp>
        <p:cxnSp>
          <p:nvCxnSpPr>
            <p:cNvPr id="72" name="Straight Arrow Connector 44">
              <a:extLst>
                <a:ext uri="{FF2B5EF4-FFF2-40B4-BE49-F238E27FC236}">
                  <a16:creationId xmlns:a16="http://schemas.microsoft.com/office/drawing/2014/main" id="{D196FC62-613A-C180-2369-27B74C50102B}"/>
                </a:ext>
              </a:extLst>
            </p:cNvPr>
            <p:cNvCxnSpPr/>
            <p:nvPr/>
          </p:nvCxnSpPr>
          <p:spPr>
            <a:xfrm flipV="1">
              <a:off x="2966435" y="2428167"/>
              <a:ext cx="3075" cy="142705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229B1F55-891F-EA8E-A776-FA2782D2689E}"/>
                </a:ext>
              </a:extLst>
            </p:cNvPr>
            <p:cNvSpPr txBox="1"/>
            <p:nvPr/>
          </p:nvSpPr>
          <p:spPr>
            <a:xfrm>
              <a:off x="4160114" y="4035065"/>
              <a:ext cx="10004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CD11b</a:t>
              </a:r>
            </a:p>
          </p:txBody>
        </p:sp>
        <p:cxnSp>
          <p:nvCxnSpPr>
            <p:cNvPr id="74" name="Straight Arrow Connector 49">
              <a:extLst>
                <a:ext uri="{FF2B5EF4-FFF2-40B4-BE49-F238E27FC236}">
                  <a16:creationId xmlns:a16="http://schemas.microsoft.com/office/drawing/2014/main" id="{17A44E03-CBC0-3EF4-AE7E-87DF317B604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21422" y="4027986"/>
              <a:ext cx="1413603" cy="1629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EE90DAFD-E1B5-B225-D291-6EF74992AA86}"/>
                </a:ext>
              </a:extLst>
            </p:cNvPr>
            <p:cNvSpPr txBox="1"/>
            <p:nvPr/>
          </p:nvSpPr>
          <p:spPr>
            <a:xfrm>
              <a:off x="6647824" y="4083630"/>
              <a:ext cx="10004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Ly6G</a:t>
              </a:r>
            </a:p>
          </p:txBody>
        </p:sp>
        <p:cxnSp>
          <p:nvCxnSpPr>
            <p:cNvPr id="80" name="Straight Arrow Connector 30">
              <a:extLst>
                <a:ext uri="{FF2B5EF4-FFF2-40B4-BE49-F238E27FC236}">
                  <a16:creationId xmlns:a16="http://schemas.microsoft.com/office/drawing/2014/main" id="{403545DA-AEE5-3560-4D0D-F3D0F95DB6B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617266" y="4075609"/>
              <a:ext cx="1413603" cy="1629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Arrow Connector 31">
              <a:extLst>
                <a:ext uri="{FF2B5EF4-FFF2-40B4-BE49-F238E27FC236}">
                  <a16:creationId xmlns:a16="http://schemas.microsoft.com/office/drawing/2014/main" id="{6CCF31DD-E6CE-804D-8E87-02503E66FE30}"/>
                </a:ext>
              </a:extLst>
            </p:cNvPr>
            <p:cNvCxnSpPr/>
            <p:nvPr/>
          </p:nvCxnSpPr>
          <p:spPr>
            <a:xfrm flipV="1">
              <a:off x="5376592" y="2456733"/>
              <a:ext cx="3075" cy="142705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04543982-FE58-AE2B-61E6-BC9F6BB527F9}"/>
                </a:ext>
              </a:extLst>
            </p:cNvPr>
            <p:cNvSpPr txBox="1"/>
            <p:nvPr/>
          </p:nvSpPr>
          <p:spPr>
            <a:xfrm rot="16200000">
              <a:off x="5020442" y="2482661"/>
              <a:ext cx="4720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Ly6C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00264B40-C59B-FAEF-407F-500FEB17A1BE}"/>
                </a:ext>
              </a:extLst>
            </p:cNvPr>
            <p:cNvSpPr txBox="1"/>
            <p:nvPr/>
          </p:nvSpPr>
          <p:spPr>
            <a:xfrm>
              <a:off x="5522907" y="2382132"/>
              <a:ext cx="7056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M-MDSC</a:t>
              </a:r>
              <a:endParaRPr lang="en-US" sz="1200" b="1" dirty="0"/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FC538B9E-E3E3-9D59-C4EE-8C43AC119705}"/>
                </a:ext>
              </a:extLst>
            </p:cNvPr>
            <p:cNvSpPr txBox="1"/>
            <p:nvPr/>
          </p:nvSpPr>
          <p:spPr>
            <a:xfrm>
              <a:off x="6152046" y="2512937"/>
              <a:ext cx="87395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PMN-MDSC</a:t>
              </a:r>
              <a:endParaRPr lang="en-US" sz="1200" b="1" dirty="0"/>
            </a:p>
          </p:txBody>
        </p:sp>
        <p:cxnSp>
          <p:nvCxnSpPr>
            <p:cNvPr id="91" name="Straight Arrow Connector 44">
              <a:extLst>
                <a:ext uri="{FF2B5EF4-FFF2-40B4-BE49-F238E27FC236}">
                  <a16:creationId xmlns:a16="http://schemas.microsoft.com/office/drawing/2014/main" id="{0AC18605-5CA9-8FC7-4669-A372411AE080}"/>
                </a:ext>
              </a:extLst>
            </p:cNvPr>
            <p:cNvCxnSpPr>
              <a:cxnSpLocks/>
            </p:cNvCxnSpPr>
            <p:nvPr/>
          </p:nvCxnSpPr>
          <p:spPr>
            <a:xfrm>
              <a:off x="4686090" y="2797628"/>
              <a:ext cx="373500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Arrow Connector 44">
              <a:extLst>
                <a:ext uri="{FF2B5EF4-FFF2-40B4-BE49-F238E27FC236}">
                  <a16:creationId xmlns:a16="http://schemas.microsoft.com/office/drawing/2014/main" id="{1CA76FE7-4DC1-ABEE-3F09-A5EAECCD0F98}"/>
                </a:ext>
              </a:extLst>
            </p:cNvPr>
            <p:cNvCxnSpPr>
              <a:cxnSpLocks/>
            </p:cNvCxnSpPr>
            <p:nvPr/>
          </p:nvCxnSpPr>
          <p:spPr>
            <a:xfrm>
              <a:off x="4686090" y="3506639"/>
              <a:ext cx="2931911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7338FC1A-C8D3-C757-57B6-FFB8C5C93327}"/>
                </a:ext>
              </a:extLst>
            </p:cNvPr>
            <p:cNvSpPr txBox="1"/>
            <p:nvPr/>
          </p:nvSpPr>
          <p:spPr>
            <a:xfrm rot="16200000">
              <a:off x="7499898" y="2460522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SSC</a:t>
              </a:r>
            </a:p>
          </p:txBody>
        </p:sp>
        <p:cxnSp>
          <p:nvCxnSpPr>
            <p:cNvPr id="96" name="Straight Arrow Connector 44">
              <a:extLst>
                <a:ext uri="{FF2B5EF4-FFF2-40B4-BE49-F238E27FC236}">
                  <a16:creationId xmlns:a16="http://schemas.microsoft.com/office/drawing/2014/main" id="{AA47D41E-D776-E817-3866-DCE744175E79}"/>
                </a:ext>
              </a:extLst>
            </p:cNvPr>
            <p:cNvCxnSpPr/>
            <p:nvPr/>
          </p:nvCxnSpPr>
          <p:spPr>
            <a:xfrm flipV="1">
              <a:off x="7802752" y="2417905"/>
              <a:ext cx="3075" cy="142705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531375CB-3CD9-466A-AE5C-9D16481CF067}"/>
                </a:ext>
              </a:extLst>
            </p:cNvPr>
            <p:cNvSpPr txBox="1"/>
            <p:nvPr/>
          </p:nvSpPr>
          <p:spPr>
            <a:xfrm>
              <a:off x="9055819" y="4045922"/>
              <a:ext cx="10004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F4/80</a:t>
              </a:r>
            </a:p>
          </p:txBody>
        </p:sp>
        <p:cxnSp>
          <p:nvCxnSpPr>
            <p:cNvPr id="98" name="Straight Arrow Connector 49">
              <a:extLst>
                <a:ext uri="{FF2B5EF4-FFF2-40B4-BE49-F238E27FC236}">
                  <a16:creationId xmlns:a16="http://schemas.microsoft.com/office/drawing/2014/main" id="{A943A16A-D81A-FEC0-0BCA-1927F2A25BB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096651" y="4076092"/>
              <a:ext cx="1413603" cy="1629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9" name="그룹 108">
            <a:extLst>
              <a:ext uri="{FF2B5EF4-FFF2-40B4-BE49-F238E27FC236}">
                <a16:creationId xmlns:a16="http://schemas.microsoft.com/office/drawing/2014/main" id="{CDCE612C-C570-B534-9DB3-BCB66B7E281D}"/>
              </a:ext>
            </a:extLst>
          </p:cNvPr>
          <p:cNvGrpSpPr/>
          <p:nvPr/>
        </p:nvGrpSpPr>
        <p:grpSpPr>
          <a:xfrm>
            <a:off x="505939" y="2281616"/>
            <a:ext cx="9646914" cy="2071003"/>
            <a:chOff x="383774" y="4428453"/>
            <a:chExt cx="9646914" cy="2071003"/>
          </a:xfrm>
        </p:grpSpPr>
        <p:pic>
          <p:nvPicPr>
            <p:cNvPr id="59" name="그림 58">
              <a:extLst>
                <a:ext uri="{FF2B5EF4-FFF2-40B4-BE49-F238E27FC236}">
                  <a16:creationId xmlns:a16="http://schemas.microsoft.com/office/drawing/2014/main" id="{CB91EF8C-1039-398A-07C5-7B778140E81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47222" y="4428453"/>
              <a:ext cx="1832542" cy="1776842"/>
            </a:xfrm>
            <a:prstGeom prst="rect">
              <a:avLst/>
            </a:prstGeom>
          </p:spPr>
        </p:pic>
        <p:pic>
          <p:nvPicPr>
            <p:cNvPr id="60" name="그림 59">
              <a:extLst>
                <a:ext uri="{FF2B5EF4-FFF2-40B4-BE49-F238E27FC236}">
                  <a16:creationId xmlns:a16="http://schemas.microsoft.com/office/drawing/2014/main" id="{5AB4390F-ADB6-5828-CA9C-AA29E4CFEA7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754523" y="4428453"/>
              <a:ext cx="1882431" cy="1825214"/>
            </a:xfrm>
            <a:prstGeom prst="rect">
              <a:avLst/>
            </a:prstGeom>
          </p:spPr>
        </p:pic>
        <p:pic>
          <p:nvPicPr>
            <p:cNvPr id="61" name="그림 60">
              <a:extLst>
                <a:ext uri="{FF2B5EF4-FFF2-40B4-BE49-F238E27FC236}">
                  <a16:creationId xmlns:a16="http://schemas.microsoft.com/office/drawing/2014/main" id="{BEF8094A-F311-C9A9-2496-D6D9AA22AA6C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174643" y="4428453"/>
              <a:ext cx="1842378" cy="1825214"/>
            </a:xfrm>
            <a:prstGeom prst="rect">
              <a:avLst/>
            </a:prstGeom>
          </p:spPr>
        </p:pic>
        <p:pic>
          <p:nvPicPr>
            <p:cNvPr id="62" name="그림 61">
              <a:extLst>
                <a:ext uri="{FF2B5EF4-FFF2-40B4-BE49-F238E27FC236}">
                  <a16:creationId xmlns:a16="http://schemas.microsoft.com/office/drawing/2014/main" id="{83B0FE1F-E7C9-3024-3FCE-A4666F7F6F7C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7591797" y="4469086"/>
              <a:ext cx="1952298" cy="1892957"/>
            </a:xfrm>
            <a:prstGeom prst="rect">
              <a:avLst/>
            </a:prstGeom>
          </p:spPr>
        </p:pic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E73024E9-5C3F-037D-78A6-4A1556B2B423}"/>
                </a:ext>
              </a:extLst>
            </p:cNvPr>
            <p:cNvSpPr txBox="1"/>
            <p:nvPr/>
          </p:nvSpPr>
          <p:spPr>
            <a:xfrm>
              <a:off x="1974660" y="6101655"/>
              <a:ext cx="4053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FSC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B2C4AEA1-CE0D-97E4-4D95-9C26BED4C58B}"/>
                </a:ext>
              </a:extLst>
            </p:cNvPr>
            <p:cNvSpPr txBox="1"/>
            <p:nvPr/>
          </p:nvSpPr>
          <p:spPr>
            <a:xfrm rot="16200000">
              <a:off x="318532" y="4558738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SSC</a:t>
              </a:r>
            </a:p>
          </p:txBody>
        </p:sp>
        <p:cxnSp>
          <p:nvCxnSpPr>
            <p:cNvPr id="69" name="Straight Arrow Connector 32">
              <a:extLst>
                <a:ext uri="{FF2B5EF4-FFF2-40B4-BE49-F238E27FC236}">
                  <a16:creationId xmlns:a16="http://schemas.microsoft.com/office/drawing/2014/main" id="{52DE6A74-A577-9F48-A39C-DE4A9ACD0AE6}"/>
                </a:ext>
              </a:extLst>
            </p:cNvPr>
            <p:cNvCxnSpPr/>
            <p:nvPr/>
          </p:nvCxnSpPr>
          <p:spPr>
            <a:xfrm flipV="1">
              <a:off x="640842" y="4516121"/>
              <a:ext cx="3075" cy="142705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Arrow Connector 33">
              <a:extLst>
                <a:ext uri="{FF2B5EF4-FFF2-40B4-BE49-F238E27FC236}">
                  <a16:creationId xmlns:a16="http://schemas.microsoft.com/office/drawing/2014/main" id="{766BB58C-A1EA-D146-B36F-EC2042835EE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58466" y="6083159"/>
              <a:ext cx="1447681" cy="13934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ABD30BDE-46EE-4FEF-58DC-767923940E0F}"/>
                </a:ext>
              </a:extLst>
            </p:cNvPr>
            <p:cNvSpPr txBox="1"/>
            <p:nvPr/>
          </p:nvSpPr>
          <p:spPr>
            <a:xfrm rot="16200000">
              <a:off x="2599572" y="4582220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SSC</a:t>
              </a:r>
            </a:p>
          </p:txBody>
        </p:sp>
        <p:cxnSp>
          <p:nvCxnSpPr>
            <p:cNvPr id="76" name="Straight Arrow Connector 44">
              <a:extLst>
                <a:ext uri="{FF2B5EF4-FFF2-40B4-BE49-F238E27FC236}">
                  <a16:creationId xmlns:a16="http://schemas.microsoft.com/office/drawing/2014/main" id="{541AFDB1-EC2D-BC62-4BB5-676872FE53BE}"/>
                </a:ext>
              </a:extLst>
            </p:cNvPr>
            <p:cNvCxnSpPr/>
            <p:nvPr/>
          </p:nvCxnSpPr>
          <p:spPr>
            <a:xfrm flipV="1">
              <a:off x="2921882" y="4539603"/>
              <a:ext cx="3075" cy="142705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BE461177-985F-B2EB-3D81-85F27E96376B}"/>
                </a:ext>
              </a:extLst>
            </p:cNvPr>
            <p:cNvSpPr txBox="1"/>
            <p:nvPr/>
          </p:nvSpPr>
          <p:spPr>
            <a:xfrm>
              <a:off x="4155493" y="6148164"/>
              <a:ext cx="10004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CD11b</a:t>
              </a:r>
            </a:p>
          </p:txBody>
        </p:sp>
        <p:cxnSp>
          <p:nvCxnSpPr>
            <p:cNvPr id="78" name="Straight Arrow Connector 49">
              <a:extLst>
                <a:ext uri="{FF2B5EF4-FFF2-40B4-BE49-F238E27FC236}">
                  <a16:creationId xmlns:a16="http://schemas.microsoft.com/office/drawing/2014/main" id="{581AAE8D-9B1E-16C9-5CF0-B72FF1A01C8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76869" y="6139422"/>
              <a:ext cx="1413603" cy="1629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5463067A-3B8F-A956-3AD8-39722238B285}"/>
                </a:ext>
              </a:extLst>
            </p:cNvPr>
            <p:cNvSpPr txBox="1"/>
            <p:nvPr/>
          </p:nvSpPr>
          <p:spPr>
            <a:xfrm>
              <a:off x="6527907" y="6105835"/>
              <a:ext cx="10004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Ly6G</a:t>
              </a:r>
            </a:p>
          </p:txBody>
        </p:sp>
        <p:cxnSp>
          <p:nvCxnSpPr>
            <p:cNvPr id="84" name="Straight Arrow Connector 30">
              <a:extLst>
                <a:ext uri="{FF2B5EF4-FFF2-40B4-BE49-F238E27FC236}">
                  <a16:creationId xmlns:a16="http://schemas.microsoft.com/office/drawing/2014/main" id="{63B1F33C-39F0-824A-B655-EDD83FAFD4F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549283" y="6136005"/>
              <a:ext cx="1413603" cy="1629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Straight Arrow Connector 31">
              <a:extLst>
                <a:ext uri="{FF2B5EF4-FFF2-40B4-BE49-F238E27FC236}">
                  <a16:creationId xmlns:a16="http://schemas.microsoft.com/office/drawing/2014/main" id="{36C64D76-F9CB-B893-868D-B13724C9DAE7}"/>
                </a:ext>
              </a:extLst>
            </p:cNvPr>
            <p:cNvCxnSpPr/>
            <p:nvPr/>
          </p:nvCxnSpPr>
          <p:spPr>
            <a:xfrm flipV="1">
              <a:off x="5308609" y="4507401"/>
              <a:ext cx="3075" cy="142705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17966683-6E0E-8B12-BEC8-55613705965E}"/>
                </a:ext>
              </a:extLst>
            </p:cNvPr>
            <p:cNvSpPr txBox="1"/>
            <p:nvPr/>
          </p:nvSpPr>
          <p:spPr>
            <a:xfrm rot="16200000">
              <a:off x="4952459" y="4533329"/>
              <a:ext cx="4720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Ly6C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15B6A17B-15F5-7E2B-2F4F-03AD7F9AE601}"/>
                </a:ext>
              </a:extLst>
            </p:cNvPr>
            <p:cNvSpPr txBox="1"/>
            <p:nvPr/>
          </p:nvSpPr>
          <p:spPr>
            <a:xfrm>
              <a:off x="5475993" y="4469086"/>
              <a:ext cx="7056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M-MDSC</a:t>
              </a:r>
              <a:endParaRPr lang="en-US" sz="1200" b="1" dirty="0"/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6FF875D8-241F-F137-909E-6ED6A4DAFF80}"/>
                </a:ext>
              </a:extLst>
            </p:cNvPr>
            <p:cNvSpPr txBox="1"/>
            <p:nvPr/>
          </p:nvSpPr>
          <p:spPr>
            <a:xfrm>
              <a:off x="6105132" y="4599891"/>
              <a:ext cx="87395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PMN-MDSC</a:t>
              </a:r>
              <a:endParaRPr lang="en-US" sz="1200" b="1" dirty="0"/>
            </a:p>
          </p:txBody>
        </p:sp>
        <p:cxnSp>
          <p:nvCxnSpPr>
            <p:cNvPr id="93" name="Straight Arrow Connector 44">
              <a:extLst>
                <a:ext uri="{FF2B5EF4-FFF2-40B4-BE49-F238E27FC236}">
                  <a16:creationId xmlns:a16="http://schemas.microsoft.com/office/drawing/2014/main" id="{16991CAB-5918-228C-8966-500D3688619E}"/>
                </a:ext>
              </a:extLst>
            </p:cNvPr>
            <p:cNvCxnSpPr>
              <a:cxnSpLocks/>
            </p:cNvCxnSpPr>
            <p:nvPr/>
          </p:nvCxnSpPr>
          <p:spPr>
            <a:xfrm>
              <a:off x="4633373" y="4865279"/>
              <a:ext cx="373500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Arrow Connector 44">
              <a:extLst>
                <a:ext uri="{FF2B5EF4-FFF2-40B4-BE49-F238E27FC236}">
                  <a16:creationId xmlns:a16="http://schemas.microsoft.com/office/drawing/2014/main" id="{2A8401BC-17CC-2224-69AB-A3CE7460F7C6}"/>
                </a:ext>
              </a:extLst>
            </p:cNvPr>
            <p:cNvCxnSpPr>
              <a:cxnSpLocks/>
            </p:cNvCxnSpPr>
            <p:nvPr/>
          </p:nvCxnSpPr>
          <p:spPr>
            <a:xfrm>
              <a:off x="4633373" y="5574290"/>
              <a:ext cx="2931911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66696932-EEE3-5311-1A05-E4FB19822886}"/>
                </a:ext>
              </a:extLst>
            </p:cNvPr>
            <p:cNvSpPr txBox="1"/>
            <p:nvPr/>
          </p:nvSpPr>
          <p:spPr>
            <a:xfrm rot="16200000">
              <a:off x="7445131" y="4598145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SSC</a:t>
              </a:r>
            </a:p>
          </p:txBody>
        </p:sp>
        <p:cxnSp>
          <p:nvCxnSpPr>
            <p:cNvPr id="100" name="Straight Arrow Connector 44">
              <a:extLst>
                <a:ext uri="{FF2B5EF4-FFF2-40B4-BE49-F238E27FC236}">
                  <a16:creationId xmlns:a16="http://schemas.microsoft.com/office/drawing/2014/main" id="{F3ACDBBB-9B95-28F0-9734-303FD5FE49C2}"/>
                </a:ext>
              </a:extLst>
            </p:cNvPr>
            <p:cNvCxnSpPr/>
            <p:nvPr/>
          </p:nvCxnSpPr>
          <p:spPr>
            <a:xfrm flipV="1">
              <a:off x="7747985" y="4555528"/>
              <a:ext cx="3075" cy="142705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19419856-660F-5FB6-7B7C-CBF8A5259126}"/>
                </a:ext>
              </a:extLst>
            </p:cNvPr>
            <p:cNvSpPr txBox="1"/>
            <p:nvPr/>
          </p:nvSpPr>
          <p:spPr>
            <a:xfrm>
              <a:off x="9030236" y="6222457"/>
              <a:ext cx="10004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F4/80</a:t>
              </a:r>
            </a:p>
          </p:txBody>
        </p:sp>
        <p:cxnSp>
          <p:nvCxnSpPr>
            <p:cNvPr id="102" name="Straight Arrow Connector 49">
              <a:extLst>
                <a:ext uri="{FF2B5EF4-FFF2-40B4-BE49-F238E27FC236}">
                  <a16:creationId xmlns:a16="http://schemas.microsoft.com/office/drawing/2014/main" id="{06E5C8BA-F2A8-D29D-966E-20D1A9FCAA2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071068" y="6252627"/>
              <a:ext cx="1413603" cy="1629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1" name="그룹 110">
            <a:extLst>
              <a:ext uri="{FF2B5EF4-FFF2-40B4-BE49-F238E27FC236}">
                <a16:creationId xmlns:a16="http://schemas.microsoft.com/office/drawing/2014/main" id="{0722AB45-669F-79DC-CFCB-D143E7C30AE5}"/>
              </a:ext>
            </a:extLst>
          </p:cNvPr>
          <p:cNvGrpSpPr/>
          <p:nvPr/>
        </p:nvGrpSpPr>
        <p:grpSpPr>
          <a:xfrm>
            <a:off x="512140" y="33665"/>
            <a:ext cx="9647610" cy="2232564"/>
            <a:chOff x="397333" y="121401"/>
            <a:chExt cx="9647610" cy="2232564"/>
          </a:xfrm>
        </p:grpSpPr>
        <p:pic>
          <p:nvPicPr>
            <p:cNvPr id="2" name="그림 1">
              <a:extLst>
                <a:ext uri="{FF2B5EF4-FFF2-40B4-BE49-F238E27FC236}">
                  <a16:creationId xmlns:a16="http://schemas.microsoft.com/office/drawing/2014/main" id="{DEC2CCAB-B57B-20B2-193A-AB1906747CD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517519" y="358831"/>
              <a:ext cx="1807391" cy="1752455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FEA0C4C-C17A-5033-1812-3B05F39918B8}"/>
                </a:ext>
              </a:extLst>
            </p:cNvPr>
            <p:cNvSpPr txBox="1"/>
            <p:nvPr/>
          </p:nvSpPr>
          <p:spPr>
            <a:xfrm>
              <a:off x="1993423" y="2040864"/>
              <a:ext cx="4053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FSC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A94F803-12E2-DE58-7290-6EDA52F32157}"/>
                </a:ext>
              </a:extLst>
            </p:cNvPr>
            <p:cNvSpPr txBox="1"/>
            <p:nvPr/>
          </p:nvSpPr>
          <p:spPr>
            <a:xfrm rot="16200000">
              <a:off x="332091" y="430367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SSC</a:t>
              </a:r>
            </a:p>
          </p:txBody>
        </p:sp>
        <p:cxnSp>
          <p:nvCxnSpPr>
            <p:cNvPr id="8" name="Straight Arrow Connector 32">
              <a:extLst>
                <a:ext uri="{FF2B5EF4-FFF2-40B4-BE49-F238E27FC236}">
                  <a16:creationId xmlns:a16="http://schemas.microsoft.com/office/drawing/2014/main" id="{1D63C420-B9F5-B4CA-7E4E-F7F082A33A8A}"/>
                </a:ext>
              </a:extLst>
            </p:cNvPr>
            <p:cNvCxnSpPr/>
            <p:nvPr/>
          </p:nvCxnSpPr>
          <p:spPr>
            <a:xfrm flipV="1">
              <a:off x="654401" y="387750"/>
              <a:ext cx="3075" cy="142705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Arrow Connector 33">
              <a:extLst>
                <a:ext uri="{FF2B5EF4-FFF2-40B4-BE49-F238E27FC236}">
                  <a16:creationId xmlns:a16="http://schemas.microsoft.com/office/drawing/2014/main" id="{A2E555FE-8801-5A15-341A-5F14B1BB29B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77229" y="2022368"/>
              <a:ext cx="1447681" cy="13934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4C02B6B-D8E9-F33D-9628-8FE64933AD5D}"/>
                </a:ext>
              </a:extLst>
            </p:cNvPr>
            <p:cNvSpPr txBox="1"/>
            <p:nvPr/>
          </p:nvSpPr>
          <p:spPr>
            <a:xfrm>
              <a:off x="992279" y="123655"/>
              <a:ext cx="127483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Viability-gate</a:t>
              </a:r>
            </a:p>
          </p:txBody>
        </p:sp>
        <p:pic>
          <p:nvPicPr>
            <p:cNvPr id="17" name="그림 16">
              <a:extLst>
                <a:ext uri="{FF2B5EF4-FFF2-40B4-BE49-F238E27FC236}">
                  <a16:creationId xmlns:a16="http://schemas.microsoft.com/office/drawing/2014/main" id="{E61C20A1-527F-4B39-E9EE-0E21C9976E48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799670" y="358142"/>
              <a:ext cx="1807392" cy="1752456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279D4DC-D9C7-A995-8A2E-32A53D7F5E8E}"/>
                </a:ext>
              </a:extLst>
            </p:cNvPr>
            <p:cNvSpPr txBox="1"/>
            <p:nvPr/>
          </p:nvSpPr>
          <p:spPr>
            <a:xfrm>
              <a:off x="3260164" y="121401"/>
              <a:ext cx="126521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CD11b</a:t>
              </a:r>
              <a:r>
                <a:rPr lang="en-US" sz="1600" baseline="30000" dirty="0"/>
                <a:t>+</a:t>
              </a:r>
              <a:r>
                <a:rPr lang="en-US" sz="1600" dirty="0"/>
                <a:t>-gate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9BE7B75-6B61-59BA-4722-B4EDC3CA7512}"/>
                </a:ext>
              </a:extLst>
            </p:cNvPr>
            <p:cNvSpPr txBox="1"/>
            <p:nvPr/>
          </p:nvSpPr>
          <p:spPr>
            <a:xfrm rot="16200000">
              <a:off x="2627832" y="420368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SSC</a:t>
              </a:r>
            </a:p>
          </p:txBody>
        </p:sp>
        <p:cxnSp>
          <p:nvCxnSpPr>
            <p:cNvPr id="25" name="Straight Arrow Connector 44">
              <a:extLst>
                <a:ext uri="{FF2B5EF4-FFF2-40B4-BE49-F238E27FC236}">
                  <a16:creationId xmlns:a16="http://schemas.microsoft.com/office/drawing/2014/main" id="{32925F61-BF46-B17A-E42B-FB673E171CAA}"/>
                </a:ext>
              </a:extLst>
            </p:cNvPr>
            <p:cNvCxnSpPr/>
            <p:nvPr/>
          </p:nvCxnSpPr>
          <p:spPr>
            <a:xfrm flipV="1">
              <a:off x="2950142" y="377751"/>
              <a:ext cx="3075" cy="142705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A7B61C58-179D-BE5A-AB50-58878BC8C023}"/>
                </a:ext>
              </a:extLst>
            </p:cNvPr>
            <p:cNvSpPr txBox="1"/>
            <p:nvPr/>
          </p:nvSpPr>
          <p:spPr>
            <a:xfrm>
              <a:off x="4183753" y="1986312"/>
              <a:ext cx="10004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CD11b</a:t>
              </a:r>
            </a:p>
          </p:txBody>
        </p:sp>
        <p:cxnSp>
          <p:nvCxnSpPr>
            <p:cNvPr id="37" name="Straight Arrow Connector 49">
              <a:extLst>
                <a:ext uri="{FF2B5EF4-FFF2-40B4-BE49-F238E27FC236}">
                  <a16:creationId xmlns:a16="http://schemas.microsoft.com/office/drawing/2014/main" id="{37101F28-D47E-CDA9-AB26-20EB1FDA4F6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05129" y="1977570"/>
              <a:ext cx="1413603" cy="1629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9" name="그룹 48">
              <a:extLst>
                <a:ext uri="{FF2B5EF4-FFF2-40B4-BE49-F238E27FC236}">
                  <a16:creationId xmlns:a16="http://schemas.microsoft.com/office/drawing/2014/main" id="{7DB47E22-8C03-A961-50C0-94166F2D4D84}"/>
                </a:ext>
              </a:extLst>
            </p:cNvPr>
            <p:cNvGrpSpPr/>
            <p:nvPr/>
          </p:nvGrpSpPr>
          <p:grpSpPr>
            <a:xfrm>
              <a:off x="5137051" y="355125"/>
              <a:ext cx="2478374" cy="1947031"/>
              <a:chOff x="5076155" y="354313"/>
              <a:chExt cx="2478374" cy="1947031"/>
            </a:xfrm>
          </p:grpSpPr>
          <p:pic>
            <p:nvPicPr>
              <p:cNvPr id="38" name="그림 37">
                <a:extLst>
                  <a:ext uri="{FF2B5EF4-FFF2-40B4-BE49-F238E27FC236}">
                    <a16:creationId xmlns:a16="http://schemas.microsoft.com/office/drawing/2014/main" id="{E90918D4-AC14-7E2B-12A7-0C3521989C7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5153693" y="360114"/>
                <a:ext cx="1807392" cy="1763174"/>
              </a:xfrm>
              <a:prstGeom prst="rect">
                <a:avLst/>
              </a:prstGeom>
            </p:spPr>
          </p:pic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FE04B245-5C92-DDAA-1FA1-F788F81F1945}"/>
                  </a:ext>
                </a:extLst>
              </p:cNvPr>
              <p:cNvSpPr txBox="1"/>
              <p:nvPr/>
            </p:nvSpPr>
            <p:spPr>
              <a:xfrm>
                <a:off x="6554077" y="2024345"/>
                <a:ext cx="100045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Ly6G</a:t>
                </a:r>
              </a:p>
            </p:txBody>
          </p:sp>
          <p:cxnSp>
            <p:nvCxnSpPr>
              <p:cNvPr id="40" name="Straight Arrow Connector 30">
                <a:extLst>
                  <a:ext uri="{FF2B5EF4-FFF2-40B4-BE49-F238E27FC236}">
                    <a16:creationId xmlns:a16="http://schemas.microsoft.com/office/drawing/2014/main" id="{642EFE56-779C-D87C-3AD4-AF1B6D3BE33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575453" y="2015603"/>
                <a:ext cx="1413603" cy="1629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Straight Arrow Connector 31">
                <a:extLst>
                  <a:ext uri="{FF2B5EF4-FFF2-40B4-BE49-F238E27FC236}">
                    <a16:creationId xmlns:a16="http://schemas.microsoft.com/office/drawing/2014/main" id="{4BE4A302-62B9-2DDA-377C-C8D508A31239}"/>
                  </a:ext>
                </a:extLst>
              </p:cNvPr>
              <p:cNvCxnSpPr/>
              <p:nvPr/>
            </p:nvCxnSpPr>
            <p:spPr>
              <a:xfrm flipV="1">
                <a:off x="5334779" y="425911"/>
                <a:ext cx="3075" cy="142705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A46339F5-493B-B028-C2DC-997553BA798A}"/>
                  </a:ext>
                </a:extLst>
              </p:cNvPr>
              <p:cNvSpPr txBox="1"/>
              <p:nvPr/>
            </p:nvSpPr>
            <p:spPr>
              <a:xfrm rot="16200000">
                <a:off x="4978629" y="451839"/>
                <a:ext cx="47205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Ly6C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A32A5074-15DA-0936-9DF7-6E9136528ADB}"/>
                  </a:ext>
                </a:extLst>
              </p:cNvPr>
              <p:cNvSpPr txBox="1"/>
              <p:nvPr/>
            </p:nvSpPr>
            <p:spPr>
              <a:xfrm>
                <a:off x="5465639" y="387750"/>
                <a:ext cx="7056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M-MDSC</a:t>
                </a:r>
                <a:endParaRPr lang="en-US" sz="1200" b="1" dirty="0"/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23ACF4FA-A441-EE4E-3B13-707EC7B9B9C6}"/>
                  </a:ext>
                </a:extLst>
              </p:cNvPr>
              <p:cNvSpPr txBox="1"/>
              <p:nvPr/>
            </p:nvSpPr>
            <p:spPr>
              <a:xfrm>
                <a:off x="6094778" y="518555"/>
                <a:ext cx="87395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PMN-MDSC</a:t>
                </a:r>
                <a:endParaRPr lang="en-US" sz="1200" b="1" dirty="0"/>
              </a:p>
            </p:txBody>
          </p:sp>
        </p:grpSp>
        <p:cxnSp>
          <p:nvCxnSpPr>
            <p:cNvPr id="45" name="Straight Arrow Connector 44">
              <a:extLst>
                <a:ext uri="{FF2B5EF4-FFF2-40B4-BE49-F238E27FC236}">
                  <a16:creationId xmlns:a16="http://schemas.microsoft.com/office/drawing/2014/main" id="{CFD0BC0B-672A-1BB8-1AB6-84C9E1F9E375}"/>
                </a:ext>
              </a:extLst>
            </p:cNvPr>
            <p:cNvCxnSpPr>
              <a:cxnSpLocks/>
            </p:cNvCxnSpPr>
            <p:nvPr/>
          </p:nvCxnSpPr>
          <p:spPr>
            <a:xfrm>
              <a:off x="4607062" y="854240"/>
              <a:ext cx="373500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Arrow Connector 44">
              <a:extLst>
                <a:ext uri="{FF2B5EF4-FFF2-40B4-BE49-F238E27FC236}">
                  <a16:creationId xmlns:a16="http://schemas.microsoft.com/office/drawing/2014/main" id="{EFFE5947-9360-DF52-6DE1-4A4263C75D33}"/>
                </a:ext>
              </a:extLst>
            </p:cNvPr>
            <p:cNvCxnSpPr>
              <a:cxnSpLocks/>
            </p:cNvCxnSpPr>
            <p:nvPr/>
          </p:nvCxnSpPr>
          <p:spPr>
            <a:xfrm>
              <a:off x="4607062" y="1563251"/>
              <a:ext cx="2931911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3" name="그림 102">
              <a:extLst>
                <a:ext uri="{FF2B5EF4-FFF2-40B4-BE49-F238E27FC236}">
                  <a16:creationId xmlns:a16="http://schemas.microsoft.com/office/drawing/2014/main" id="{FBDB6FD0-E8DD-12F7-706E-F166CAC70477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7658770" y="359378"/>
              <a:ext cx="1884518" cy="1827238"/>
            </a:xfrm>
            <a:prstGeom prst="rect">
              <a:avLst/>
            </a:prstGeom>
          </p:spPr>
        </p:pic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D46BD57C-F39D-5E93-AAE5-C7A7EBA200CD}"/>
                </a:ext>
              </a:extLst>
            </p:cNvPr>
            <p:cNvSpPr txBox="1"/>
            <p:nvPr/>
          </p:nvSpPr>
          <p:spPr>
            <a:xfrm rot="16200000">
              <a:off x="7488570" y="491566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SSC</a:t>
              </a:r>
            </a:p>
          </p:txBody>
        </p:sp>
        <p:cxnSp>
          <p:nvCxnSpPr>
            <p:cNvPr id="105" name="Straight Arrow Connector 44">
              <a:extLst>
                <a:ext uri="{FF2B5EF4-FFF2-40B4-BE49-F238E27FC236}">
                  <a16:creationId xmlns:a16="http://schemas.microsoft.com/office/drawing/2014/main" id="{1368E38F-53CD-ED95-ADA8-9E4C175A4071}"/>
                </a:ext>
              </a:extLst>
            </p:cNvPr>
            <p:cNvCxnSpPr/>
            <p:nvPr/>
          </p:nvCxnSpPr>
          <p:spPr>
            <a:xfrm flipV="1">
              <a:off x="7791424" y="448949"/>
              <a:ext cx="3075" cy="142705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0FDEC438-0B37-C1D7-A3DC-05BC573EA635}"/>
                </a:ext>
              </a:extLst>
            </p:cNvPr>
            <p:cNvSpPr txBox="1"/>
            <p:nvPr/>
          </p:nvSpPr>
          <p:spPr>
            <a:xfrm>
              <a:off x="9044491" y="2076966"/>
              <a:ext cx="10004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F4/80</a:t>
              </a:r>
            </a:p>
          </p:txBody>
        </p:sp>
        <p:cxnSp>
          <p:nvCxnSpPr>
            <p:cNvPr id="107" name="Straight Arrow Connector 49">
              <a:extLst>
                <a:ext uri="{FF2B5EF4-FFF2-40B4-BE49-F238E27FC236}">
                  <a16:creationId xmlns:a16="http://schemas.microsoft.com/office/drawing/2014/main" id="{D54EFE39-7742-7C3B-15FE-2B83241C305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085323" y="2107136"/>
              <a:ext cx="1413603" cy="1629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2" name="TextBox 111">
            <a:extLst>
              <a:ext uri="{FF2B5EF4-FFF2-40B4-BE49-F238E27FC236}">
                <a16:creationId xmlns:a16="http://schemas.microsoft.com/office/drawing/2014/main" id="{850DD3C9-A9DD-7255-43F1-0D2BD7846876}"/>
              </a:ext>
            </a:extLst>
          </p:cNvPr>
          <p:cNvSpPr txBox="1"/>
          <p:nvPr/>
        </p:nvSpPr>
        <p:spPr>
          <a:xfrm>
            <a:off x="8828842" y="345217"/>
            <a:ext cx="9188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acrophage</a:t>
            </a:r>
            <a:endParaRPr lang="en-US" sz="1200" b="1" dirty="0"/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2243F276-2359-3B42-57D9-CA4AED2AB00C}"/>
              </a:ext>
            </a:extLst>
          </p:cNvPr>
          <p:cNvSpPr txBox="1"/>
          <p:nvPr/>
        </p:nvSpPr>
        <p:spPr>
          <a:xfrm>
            <a:off x="8828843" y="2405733"/>
            <a:ext cx="9188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acrophage</a:t>
            </a:r>
            <a:endParaRPr lang="en-US" sz="1200" b="1" dirty="0"/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BC2D9F05-F0F7-5C88-8F4F-0B3CAF7BB80A}"/>
              </a:ext>
            </a:extLst>
          </p:cNvPr>
          <p:cNvSpPr txBox="1"/>
          <p:nvPr/>
        </p:nvSpPr>
        <p:spPr>
          <a:xfrm>
            <a:off x="8920809" y="4375810"/>
            <a:ext cx="9188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acrophage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4537193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F665E440-2DB6-48B8-8AE2-73D5D6729A2F}"/>
              </a:ext>
            </a:extLst>
          </p:cNvPr>
          <p:cNvSpPr txBox="1">
            <a:spLocks noChangeArrowheads="1"/>
          </p:cNvSpPr>
          <p:nvPr/>
        </p:nvSpPr>
        <p:spPr>
          <a:xfrm>
            <a:off x="0" y="5197429"/>
            <a:ext cx="12192000" cy="130674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45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2. TTP deficiency causes expansion of myeloid populations in female as well. </a:t>
            </a:r>
            <a:r>
              <a:rPr lang="en-US" sz="14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 Flow cytometry analysis of M-MDSC populations in bone marrow and spleen. (B) Flow cytometry analysis of PMN-MDSC populations in bone marrow and spleen. (C) Flow cytometry analysis of macrophages in bone marrow and spleen. One-way analysis of variance with Tukey’s multiple comparisons test and unpaired </a:t>
            </a:r>
            <a:r>
              <a:rPr lang="en-US" sz="1400" i="1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4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est data are presented as mean ± SEM, *P &lt; 0.05, **P &lt; 0.01, ***P &lt; 0.001, ****P &lt; 0.0001.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9CB82F2-1008-4CDA-AF80-F50304C69E51}"/>
              </a:ext>
            </a:extLst>
          </p:cNvPr>
          <p:cNvSpPr txBox="1"/>
          <p:nvPr/>
        </p:nvSpPr>
        <p:spPr>
          <a:xfrm>
            <a:off x="0" y="564944"/>
            <a:ext cx="301083" cy="4566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367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C0DC893-1650-454C-8408-6CB3CFDFA84E}"/>
              </a:ext>
            </a:extLst>
          </p:cNvPr>
          <p:cNvSpPr txBox="1"/>
          <p:nvPr/>
        </p:nvSpPr>
        <p:spPr>
          <a:xfrm>
            <a:off x="4117521" y="564944"/>
            <a:ext cx="301083" cy="4566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367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71CBD78-DFE5-4802-BC1D-9026A9943841}"/>
              </a:ext>
            </a:extLst>
          </p:cNvPr>
          <p:cNvSpPr txBox="1"/>
          <p:nvPr/>
        </p:nvSpPr>
        <p:spPr>
          <a:xfrm>
            <a:off x="8218623" y="564944"/>
            <a:ext cx="301083" cy="4566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367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8" name="Object 5">
            <a:extLst>
              <a:ext uri="{FF2B5EF4-FFF2-40B4-BE49-F238E27FC236}">
                <a16:creationId xmlns:a16="http://schemas.microsoft.com/office/drawing/2014/main" id="{0CD86995-802B-487F-965B-01B46456A62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0741064"/>
              </p:ext>
            </p:extLst>
          </p:nvPr>
        </p:nvGraphicFramePr>
        <p:xfrm>
          <a:off x="8735354" y="1046884"/>
          <a:ext cx="2600325" cy="3197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2600900" imgH="3197087" progId="Prism9.Document">
                  <p:embed/>
                </p:oleObj>
              </mc:Choice>
              <mc:Fallback>
                <p:oleObj name="Prism 9" r:id="rId3" imgW="2600900" imgH="3197087" progId="Prism9.Document">
                  <p:embed/>
                  <p:pic>
                    <p:nvPicPr>
                      <p:cNvPr id="40" name="Object 5">
                        <a:extLst>
                          <a:ext uri="{FF2B5EF4-FFF2-40B4-BE49-F238E27FC236}">
                            <a16:creationId xmlns:a16="http://schemas.microsoft.com/office/drawing/2014/main" id="{31DA0955-0381-4EE6-A5DA-60CCE4345CE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735354" y="1046884"/>
                        <a:ext cx="2600325" cy="3197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0B90E9F1-5936-4067-9C89-C37997EA1B9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86938566"/>
              </p:ext>
            </p:extLst>
          </p:nvPr>
        </p:nvGraphicFramePr>
        <p:xfrm>
          <a:off x="604179" y="875434"/>
          <a:ext cx="2600325" cy="3414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2600900" imgH="3415341" progId="Prism9.Document">
                  <p:embed/>
                </p:oleObj>
              </mc:Choice>
              <mc:Fallback>
                <p:oleObj name="Prism 9" r:id="rId5" imgW="2600900" imgH="3415341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5422C522-A4B9-4AD6-BC19-8684F3929DE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04179" y="875434"/>
                        <a:ext cx="2600325" cy="34147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1138AD90-A013-490F-9B84-EA5733AECB6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98067638"/>
              </p:ext>
            </p:extLst>
          </p:nvPr>
        </p:nvGraphicFramePr>
        <p:xfrm>
          <a:off x="4636429" y="1007197"/>
          <a:ext cx="2595562" cy="3278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2596218" imgH="3278122" progId="Prism9.Document">
                  <p:embed/>
                </p:oleObj>
              </mc:Choice>
              <mc:Fallback>
                <p:oleObj name="Prism 9" r:id="rId7" imgW="2596218" imgH="3278122" progId="Prism9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719B5FF5-07E6-40F3-AD90-EA4D90FC5C1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636429" y="1007197"/>
                        <a:ext cx="2595562" cy="3278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4B6F951C-6F69-814E-AE99-31757325FAE5}"/>
              </a:ext>
            </a:extLst>
          </p:cNvPr>
          <p:cNvSpPr txBox="1"/>
          <p:nvPr/>
        </p:nvSpPr>
        <p:spPr>
          <a:xfrm>
            <a:off x="1684683" y="639355"/>
            <a:ext cx="9294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M-MDSC</a:t>
            </a:r>
            <a:endParaRPr lang="ko-KR" altLang="en-US" sz="14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CBF763D-D2EA-F545-86E2-FB6FD09C0B3F}"/>
              </a:ext>
            </a:extLst>
          </p:cNvPr>
          <p:cNvSpPr txBox="1"/>
          <p:nvPr/>
        </p:nvSpPr>
        <p:spPr>
          <a:xfrm>
            <a:off x="5591206" y="639355"/>
            <a:ext cx="11224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PMN-MDSC</a:t>
            </a:r>
            <a:endParaRPr lang="ko-KR" altLang="en-US" sz="14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33900D0-0B34-E74A-A1A4-351B7241EBA9}"/>
              </a:ext>
            </a:extLst>
          </p:cNvPr>
          <p:cNvSpPr txBox="1"/>
          <p:nvPr/>
        </p:nvSpPr>
        <p:spPr>
          <a:xfrm>
            <a:off x="9841605" y="639355"/>
            <a:ext cx="11224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Macrophage</a:t>
            </a:r>
            <a:endParaRPr lang="ko-KR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8767083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E2D4DF9B-D5D3-4615-ADA2-3D137C418253}"/>
              </a:ext>
            </a:extLst>
          </p:cNvPr>
          <p:cNvSpPr txBox="1">
            <a:spLocks noChangeArrowheads="1"/>
          </p:cNvSpPr>
          <p:nvPr/>
        </p:nvSpPr>
        <p:spPr>
          <a:xfrm>
            <a:off x="-1" y="5814092"/>
            <a:ext cx="12155485" cy="101963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45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1400" b="1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3. TTP deficiency causes expansion of M-MDSCs but no change in inflammatory monocytes. </a:t>
            </a:r>
            <a:r>
              <a:rPr lang="en-US" sz="14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 Flow cytometry analysis of M-MDSC (CD11c</a:t>
            </a:r>
            <a:r>
              <a:rPr lang="en-US" sz="1400" baseline="300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4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  <a:r>
              <a:rPr lang="en-US" sz="1400" baseline="300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4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6G</a:t>
            </a:r>
            <a:r>
              <a:rPr lang="en-US" sz="1400" baseline="300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en-US" sz="14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6C</a:t>
            </a:r>
            <a:r>
              <a:rPr lang="en-US" sz="1400" baseline="300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4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24</a:t>
            </a:r>
            <a:r>
              <a:rPr lang="en-US" sz="1400" baseline="300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4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and inflammatory monocyte (CD11c</a:t>
            </a:r>
            <a:r>
              <a:rPr lang="en-US" sz="1400" baseline="300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4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  <a:r>
              <a:rPr lang="en-US" sz="1400" baseline="300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4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6G</a:t>
            </a:r>
            <a:r>
              <a:rPr lang="en-US" sz="1400" baseline="300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en-US" sz="14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6C</a:t>
            </a:r>
            <a:r>
              <a:rPr lang="en-US" sz="1400" baseline="300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4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24</a:t>
            </a:r>
            <a:r>
              <a:rPr lang="en-US" sz="1400" baseline="300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en-US" sz="14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populations in bone marrow. (B) Flow cytometry analysis of M-MDSC and inflammatory monocyte populations in spleen. Unpaired </a:t>
            </a:r>
            <a:r>
              <a:rPr lang="en-US" sz="1400" i="1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4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est, data are presented as mean ± SEM, *P &lt; 0.05. 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0960C24-5B13-4B28-B032-2A95DCCE4ABC}"/>
              </a:ext>
            </a:extLst>
          </p:cNvPr>
          <p:cNvSpPr txBox="1"/>
          <p:nvPr/>
        </p:nvSpPr>
        <p:spPr>
          <a:xfrm>
            <a:off x="0" y="0"/>
            <a:ext cx="301083" cy="4566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367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BD257CD-D899-4492-86DE-6B0DFD00F13C}"/>
              </a:ext>
            </a:extLst>
          </p:cNvPr>
          <p:cNvSpPr txBox="1"/>
          <p:nvPr/>
        </p:nvSpPr>
        <p:spPr>
          <a:xfrm>
            <a:off x="4840013" y="211264"/>
            <a:ext cx="4516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M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84BA9EA-4322-4AFA-806B-BFE9B7DE91FF}"/>
              </a:ext>
            </a:extLst>
          </p:cNvPr>
          <p:cNvSpPr txBox="1"/>
          <p:nvPr/>
        </p:nvSpPr>
        <p:spPr>
          <a:xfrm>
            <a:off x="4840013" y="3094717"/>
            <a:ext cx="4881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P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7CC7E17-7A68-40B7-B5C9-5AE93D324C9E}"/>
              </a:ext>
            </a:extLst>
          </p:cNvPr>
          <p:cNvSpPr txBox="1"/>
          <p:nvPr/>
        </p:nvSpPr>
        <p:spPr>
          <a:xfrm>
            <a:off x="-1" y="2741491"/>
            <a:ext cx="301083" cy="4566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367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2515EC90-BEEC-4330-87A0-D65DD604D45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61290855"/>
              </p:ext>
            </p:extLst>
          </p:nvPr>
        </p:nvGraphicFramePr>
        <p:xfrm>
          <a:off x="6900338" y="301275"/>
          <a:ext cx="3109129" cy="14222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4399778" imgH="2012541" progId="Prism9.Document">
                  <p:embed/>
                </p:oleObj>
              </mc:Choice>
              <mc:Fallback>
                <p:oleObj name="Prism 9" r:id="rId3" imgW="4399778" imgH="2012541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7B18BCED-F21C-4720-BDA4-DEE3A030114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900338" y="301275"/>
                        <a:ext cx="3109129" cy="14222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9E588E1A-E37B-4B4C-8F7F-6D300733EAA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3193194"/>
              </p:ext>
            </p:extLst>
          </p:nvPr>
        </p:nvGraphicFramePr>
        <p:xfrm>
          <a:off x="6900337" y="1396566"/>
          <a:ext cx="3109130" cy="14725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4363404" imgH="2067284" progId="Prism9.Document">
                  <p:embed/>
                </p:oleObj>
              </mc:Choice>
              <mc:Fallback>
                <p:oleObj name="Prism 9" r:id="rId5" imgW="4363404" imgH="2067284" progId="Prism9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B1B2905D-C6B3-4CD6-A771-9231337BBEF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900337" y="1396566"/>
                        <a:ext cx="3109130" cy="14725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7C6A46C5-F1F0-46B9-B8A6-B996A9E2240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40451319"/>
              </p:ext>
            </p:extLst>
          </p:nvPr>
        </p:nvGraphicFramePr>
        <p:xfrm>
          <a:off x="6817521" y="3298879"/>
          <a:ext cx="3109129" cy="14222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4399778" imgH="2012541" progId="Prism9.Document">
                  <p:embed/>
                </p:oleObj>
              </mc:Choice>
              <mc:Fallback>
                <p:oleObj name="Prism 9" r:id="rId7" imgW="4399778" imgH="2012541" progId="Prism9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CCBA7692-2491-4136-8137-15E22B2C9B1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817521" y="3298879"/>
                        <a:ext cx="3109129" cy="14222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860B3F9A-4D4F-4EFA-87F8-038B8A3E6BB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77761492"/>
              </p:ext>
            </p:extLst>
          </p:nvPr>
        </p:nvGraphicFramePr>
        <p:xfrm>
          <a:off x="6863824" y="4326378"/>
          <a:ext cx="3109129" cy="14985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4363404" imgH="2104020" progId="Prism9.Document">
                  <p:embed/>
                </p:oleObj>
              </mc:Choice>
              <mc:Fallback>
                <p:oleObj name="Prism 9" r:id="rId9" imgW="4363404" imgH="2104020" progId="Prism9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87AA424D-9783-4A6F-9D0C-C775D4F2435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863824" y="4326378"/>
                        <a:ext cx="3109129" cy="14985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0" name="그룹 19">
            <a:extLst>
              <a:ext uri="{FF2B5EF4-FFF2-40B4-BE49-F238E27FC236}">
                <a16:creationId xmlns:a16="http://schemas.microsoft.com/office/drawing/2014/main" id="{3A61A154-D772-4256-7E1E-1C63F4F7BB9E}"/>
              </a:ext>
            </a:extLst>
          </p:cNvPr>
          <p:cNvGrpSpPr/>
          <p:nvPr/>
        </p:nvGrpSpPr>
        <p:grpSpPr>
          <a:xfrm>
            <a:off x="631103" y="488263"/>
            <a:ext cx="3658320" cy="2147141"/>
            <a:chOff x="667618" y="1035797"/>
            <a:chExt cx="3658320" cy="2147141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FF5C361-5A6E-3742-290A-32408C630913}"/>
                </a:ext>
              </a:extLst>
            </p:cNvPr>
            <p:cNvSpPr txBox="1"/>
            <p:nvPr/>
          </p:nvSpPr>
          <p:spPr>
            <a:xfrm rot="16200000">
              <a:off x="1778187" y="1961538"/>
              <a:ext cx="20669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D11c</a:t>
              </a:r>
              <a:r>
                <a:rPr lang="en-US" altLang="ko-KR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D11b</a:t>
              </a:r>
              <a:r>
                <a:rPr lang="en-US" altLang="ko-KR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y6G</a:t>
              </a:r>
              <a:r>
                <a:rPr lang="en-US" altLang="ko-KR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y6C</a:t>
              </a:r>
              <a:r>
                <a:rPr lang="en-US" altLang="ko-KR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hi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D124</a:t>
              </a:r>
              <a:r>
                <a:rPr lang="en-US" altLang="ko-KR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  <a:endParaRPr lang="ko-KR" altLang="en-US" sz="8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2" name="그룹 21">
              <a:extLst>
                <a:ext uri="{FF2B5EF4-FFF2-40B4-BE49-F238E27FC236}">
                  <a16:creationId xmlns:a16="http://schemas.microsoft.com/office/drawing/2014/main" id="{C5298E63-565E-0874-4ED5-CF391A33E8AC}"/>
                </a:ext>
              </a:extLst>
            </p:cNvPr>
            <p:cNvGrpSpPr/>
            <p:nvPr/>
          </p:nvGrpSpPr>
          <p:grpSpPr>
            <a:xfrm>
              <a:off x="667618" y="1132093"/>
              <a:ext cx="3658320" cy="2050845"/>
              <a:chOff x="667618" y="1132093"/>
              <a:chExt cx="3658320" cy="2050845"/>
            </a:xfrm>
          </p:grpSpPr>
          <p:graphicFrame>
            <p:nvGraphicFramePr>
              <p:cNvPr id="23" name="Object 14">
                <a:extLst>
                  <a:ext uri="{FF2B5EF4-FFF2-40B4-BE49-F238E27FC236}">
                    <a16:creationId xmlns:a16="http://schemas.microsoft.com/office/drawing/2014/main" id="{DECCF79E-BCFD-E7A6-1BDC-5339EB838403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550383787"/>
                  </p:ext>
                </p:extLst>
              </p:nvPr>
            </p:nvGraphicFramePr>
            <p:xfrm>
              <a:off x="2832100" y="1279525"/>
              <a:ext cx="1493838" cy="190341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11" imgW="2190706" imgH="2792995" progId="Prism9.Document">
                      <p:embed/>
                    </p:oleObj>
                  </mc:Choice>
                  <mc:Fallback>
                    <p:oleObj name="Prism 9" r:id="rId11" imgW="2190706" imgH="2792995" progId="Prism9.Document">
                      <p:embed/>
                      <p:pic>
                        <p:nvPicPr>
                          <p:cNvPr id="4" name="Object 14">
                            <a:extLst>
                              <a:ext uri="{FF2B5EF4-FFF2-40B4-BE49-F238E27FC236}">
                                <a16:creationId xmlns:a16="http://schemas.microsoft.com/office/drawing/2014/main" id="{BA62831D-0962-2B88-896E-58F9A5AD639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2"/>
                          <a:stretch>
                            <a:fillRect/>
                          </a:stretch>
                        </p:blipFill>
                        <p:spPr>
                          <a:xfrm>
                            <a:off x="2832100" y="1279525"/>
                            <a:ext cx="1493838" cy="190341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pic>
            <p:nvPicPr>
              <p:cNvPr id="24" name="그림 23">
                <a:extLst>
                  <a:ext uri="{FF2B5EF4-FFF2-40B4-BE49-F238E27FC236}">
                    <a16:creationId xmlns:a16="http://schemas.microsoft.com/office/drawing/2014/main" id="{874EE456-916D-FE59-77C3-C364D21847F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/>
              <a:srcRect l="32500" t="29413" r="65000" b="28365"/>
              <a:stretch/>
            </p:blipFill>
            <p:spPr>
              <a:xfrm>
                <a:off x="667618" y="1132093"/>
                <a:ext cx="192474" cy="1828510"/>
              </a:xfrm>
              <a:prstGeom prst="rect">
                <a:avLst/>
              </a:prstGeom>
            </p:spPr>
          </p:pic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62494525-5F0A-83A4-3250-DC3921946F90}"/>
                  </a:ext>
                </a:extLst>
              </p:cNvPr>
              <p:cNvSpPr txBox="1"/>
              <p:nvPr/>
            </p:nvSpPr>
            <p:spPr>
              <a:xfrm rot="16200000">
                <a:off x="584854" y="1866764"/>
                <a:ext cx="74780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-MDSC</a:t>
                </a:r>
                <a:endParaRPr lang="ko-KR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6" name="그림 25">
                <a:extLst>
                  <a:ext uri="{FF2B5EF4-FFF2-40B4-BE49-F238E27FC236}">
                    <a16:creationId xmlns:a16="http://schemas.microsoft.com/office/drawing/2014/main" id="{B4AE9C3C-9055-D9BD-93B7-E40FA19C42E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/>
              <a:srcRect l="34706" t="34804" r="47941" b="25621"/>
              <a:stretch/>
            </p:blipFill>
            <p:spPr>
              <a:xfrm>
                <a:off x="1074173" y="1349273"/>
                <a:ext cx="1345817" cy="1726456"/>
              </a:xfrm>
              <a:prstGeom prst="rect">
                <a:avLst/>
              </a:prstGeom>
            </p:spPr>
          </p:pic>
        </p:grpSp>
      </p:grpSp>
      <p:grpSp>
        <p:nvGrpSpPr>
          <p:cNvPr id="27" name="그룹 26">
            <a:extLst>
              <a:ext uri="{FF2B5EF4-FFF2-40B4-BE49-F238E27FC236}">
                <a16:creationId xmlns:a16="http://schemas.microsoft.com/office/drawing/2014/main" id="{5DBD3EFA-548C-0EB8-0A2B-89668E4E9CE9}"/>
              </a:ext>
            </a:extLst>
          </p:cNvPr>
          <p:cNvGrpSpPr/>
          <p:nvPr/>
        </p:nvGrpSpPr>
        <p:grpSpPr>
          <a:xfrm>
            <a:off x="631103" y="3375286"/>
            <a:ext cx="3786061" cy="2281014"/>
            <a:chOff x="667618" y="3387117"/>
            <a:chExt cx="3786061" cy="2281014"/>
          </a:xfrm>
        </p:grpSpPr>
        <p:graphicFrame>
          <p:nvGraphicFramePr>
            <p:cNvPr id="28" name="Object 16">
              <a:extLst>
                <a:ext uri="{FF2B5EF4-FFF2-40B4-BE49-F238E27FC236}">
                  <a16:creationId xmlns:a16="http://schemas.microsoft.com/office/drawing/2014/main" id="{B933CAA8-7F0F-B81E-4FE9-DC6FA954AEA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4201493"/>
                </p:ext>
              </p:extLst>
            </p:nvPr>
          </p:nvGraphicFramePr>
          <p:xfrm>
            <a:off x="2832100" y="3601206"/>
            <a:ext cx="1621579" cy="20669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5" imgW="2190706" imgH="2792995" progId="Prism9.Document">
                    <p:embed/>
                  </p:oleObj>
                </mc:Choice>
                <mc:Fallback>
                  <p:oleObj name="Prism 9" r:id="rId15" imgW="2190706" imgH="2792995" progId="Prism9.Document">
                    <p:embed/>
                    <p:pic>
                      <p:nvPicPr>
                        <p:cNvPr id="5" name="Object 16">
                          <a:extLst>
                            <a:ext uri="{FF2B5EF4-FFF2-40B4-BE49-F238E27FC236}">
                              <a16:creationId xmlns:a16="http://schemas.microsoft.com/office/drawing/2014/main" id="{D5016530-C3C0-456B-C4E1-D183191AB09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2832100" y="3601206"/>
                          <a:ext cx="1621579" cy="20669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29" name="그림 28">
              <a:extLst>
                <a:ext uri="{FF2B5EF4-FFF2-40B4-BE49-F238E27FC236}">
                  <a16:creationId xmlns:a16="http://schemas.microsoft.com/office/drawing/2014/main" id="{781CFCA9-677F-D6E6-1453-2947A562DF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/>
            <a:srcRect l="30074" t="35686" r="52794" b="24314"/>
            <a:stretch/>
          </p:blipFill>
          <p:spPr>
            <a:xfrm>
              <a:off x="1074173" y="3601206"/>
              <a:ext cx="1523495" cy="2000813"/>
            </a:xfrm>
            <a:prstGeom prst="rect">
              <a:avLst/>
            </a:prstGeom>
          </p:spPr>
        </p:pic>
        <p:pic>
          <p:nvPicPr>
            <p:cNvPr id="30" name="그림 29">
              <a:extLst>
                <a:ext uri="{FF2B5EF4-FFF2-40B4-BE49-F238E27FC236}">
                  <a16:creationId xmlns:a16="http://schemas.microsoft.com/office/drawing/2014/main" id="{55F4B884-AD8C-A1CE-6E67-344A3ECD85B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32500" t="29413" r="65000" b="28365"/>
            <a:stretch/>
          </p:blipFill>
          <p:spPr>
            <a:xfrm>
              <a:off x="667618" y="3506325"/>
              <a:ext cx="192474" cy="1828510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323EC959-635B-46F2-B002-1B632F2CED2C}"/>
                </a:ext>
              </a:extLst>
            </p:cNvPr>
            <p:cNvSpPr txBox="1"/>
            <p:nvPr/>
          </p:nvSpPr>
          <p:spPr>
            <a:xfrm rot="16200000">
              <a:off x="584854" y="4305164"/>
              <a:ext cx="74780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-MDSC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F455C62C-CAE2-ECD5-35F2-8CD5F0B64021}"/>
                </a:ext>
              </a:extLst>
            </p:cNvPr>
            <p:cNvSpPr txBox="1"/>
            <p:nvPr/>
          </p:nvSpPr>
          <p:spPr>
            <a:xfrm rot="16200000">
              <a:off x="1798637" y="4312858"/>
              <a:ext cx="20669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D11c</a:t>
              </a:r>
              <a:r>
                <a:rPr lang="en-US" altLang="ko-KR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D11b</a:t>
              </a:r>
              <a:r>
                <a:rPr lang="en-US" altLang="ko-KR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y6G</a:t>
              </a:r>
              <a:r>
                <a:rPr lang="en-US" altLang="ko-KR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y6C</a:t>
              </a:r>
              <a:r>
                <a:rPr lang="en-US" altLang="ko-KR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hi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D124</a:t>
              </a:r>
              <a:r>
                <a:rPr lang="en-US" altLang="ko-KR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  <a:endParaRPr lang="ko-KR" altLang="en-US" sz="8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160777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17FEFE5-EDC2-492C-B7E0-3F3D6E1E92BE}"/>
              </a:ext>
            </a:extLst>
          </p:cNvPr>
          <p:cNvSpPr txBox="1"/>
          <p:nvPr/>
        </p:nvSpPr>
        <p:spPr>
          <a:xfrm>
            <a:off x="27709" y="7672"/>
            <a:ext cx="301083" cy="4566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367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B09A15D-76DF-4F4C-B037-A6F0A0FCE74E}"/>
              </a:ext>
            </a:extLst>
          </p:cNvPr>
          <p:cNvSpPr txBox="1"/>
          <p:nvPr/>
        </p:nvSpPr>
        <p:spPr>
          <a:xfrm>
            <a:off x="4316816" y="7672"/>
            <a:ext cx="301083" cy="4566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367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42EDF027-743D-4109-84EF-AC6D1AB77F1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2" b="6255"/>
          <a:stretch/>
        </p:blipFill>
        <p:spPr>
          <a:xfrm>
            <a:off x="83128" y="1091037"/>
            <a:ext cx="3985497" cy="4190448"/>
          </a:xfrm>
          <a:prstGeom prst="rect">
            <a:avLst/>
          </a:prstGeom>
        </p:spPr>
      </p:pic>
      <p:sp>
        <p:nvSpPr>
          <p:cNvPr id="17" name="Rectangle 2">
            <a:extLst>
              <a:ext uri="{FF2B5EF4-FFF2-40B4-BE49-F238E27FC236}">
                <a16:creationId xmlns:a16="http://schemas.microsoft.com/office/drawing/2014/main" id="{8143B5AB-7E9C-4A21-992D-F9D00EAF5CE7}"/>
              </a:ext>
            </a:extLst>
          </p:cNvPr>
          <p:cNvSpPr txBox="1">
            <a:spLocks noChangeArrowheads="1"/>
          </p:cNvSpPr>
          <p:nvPr/>
        </p:nvSpPr>
        <p:spPr>
          <a:xfrm>
            <a:off x="0" y="6101404"/>
            <a:ext cx="12192000" cy="728951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45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4. Quantitative cell cycle phase analysis in single-cell RNA-seq data of bone marrow-derived cells reveals subtle differences in myeloid progenitor populations. </a:t>
            </a:r>
            <a:r>
              <a:rPr lang="en-US" sz="14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 The percentage of cells in each annotated cluster, plotted as a percentage of total cells sequenced in control, </a:t>
            </a:r>
            <a:r>
              <a:rPr lang="en-US" sz="1400" dirty="0" err="1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TPKO</a:t>
            </a:r>
            <a:r>
              <a:rPr lang="en-US" sz="1400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and TTPKO mice. (B) Cell Cycle Phase Scoring UMAPs. Cells were scored based on expression of G2/M and S phase marker genes. Cell cycle phase scoring is consistent across the three samples.  (C) Phase percentage of myeloid progenitor population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A151D10-41A2-9580-EBB9-5888110AA014}"/>
              </a:ext>
            </a:extLst>
          </p:cNvPr>
          <p:cNvSpPr txBox="1"/>
          <p:nvPr/>
        </p:nvSpPr>
        <p:spPr>
          <a:xfrm>
            <a:off x="4323384" y="3365081"/>
            <a:ext cx="301083" cy="4566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367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18" name="개체 17">
            <a:extLst>
              <a:ext uri="{FF2B5EF4-FFF2-40B4-BE49-F238E27FC236}">
                <a16:creationId xmlns:a16="http://schemas.microsoft.com/office/drawing/2014/main" id="{C93B9BF7-BEB6-0913-82C8-19378AAAF1D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3653744"/>
              </p:ext>
            </p:extLst>
          </p:nvPr>
        </p:nvGraphicFramePr>
        <p:xfrm>
          <a:off x="4879226" y="3469987"/>
          <a:ext cx="3029446" cy="26314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696731" imgH="3210858" progId="Prism9.Document">
                  <p:embed/>
                </p:oleObj>
              </mc:Choice>
              <mc:Fallback>
                <p:oleObj name="Prism 9" r:id="rId4" imgW="3696731" imgH="321085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879226" y="3469987"/>
                        <a:ext cx="3029446" cy="26314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9" name="Picture 18">
            <a:extLst>
              <a:ext uri="{FF2B5EF4-FFF2-40B4-BE49-F238E27FC236}">
                <a16:creationId xmlns:a16="http://schemas.microsoft.com/office/drawing/2014/main" id="{130E2518-FB07-97FE-E418-FA08DBA6A01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9226" y="326824"/>
            <a:ext cx="4448014" cy="28594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54460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565F32E-5F9F-26F8-E187-AB8F4B1C9D2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4250" y="0"/>
            <a:ext cx="4469324" cy="595909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D5421E8-3211-CD74-95A5-F1A6F6B568D3}"/>
              </a:ext>
            </a:extLst>
          </p:cNvPr>
          <p:cNvSpPr txBox="1"/>
          <p:nvPr/>
        </p:nvSpPr>
        <p:spPr>
          <a:xfrm>
            <a:off x="85241" y="6059837"/>
            <a:ext cx="12251410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313BB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5: M-MDSC egress genes are weakly expressed in mesenchymal stem cell populations. </a:t>
            </a:r>
            <a:r>
              <a:rPr lang="en-US" sz="1400" dirty="0" err="1">
                <a:solidFill>
                  <a:srgbClr val="313BB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tplot</a:t>
            </a:r>
            <a:r>
              <a:rPr lang="en-US" sz="1400" dirty="0">
                <a:solidFill>
                  <a:srgbClr val="313BB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howing the expression of genes that contribute to M-MDSC mobilization for all cell types within the bone marrow of control, TTP KO, and </a:t>
            </a:r>
            <a:r>
              <a:rPr lang="en-US" sz="1400" dirty="0" err="1">
                <a:solidFill>
                  <a:srgbClr val="313BB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TPKO</a:t>
            </a:r>
            <a:r>
              <a:rPr lang="en-US" sz="1400" dirty="0">
                <a:solidFill>
                  <a:srgbClr val="313BB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A low number of cells in the Mesenchymal Stem Cell cluster, highlighted with a red box, expressing these genes (&lt;25%) at low levels of all egress-associated  genes. 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CDB8AF9-8447-B090-0458-6FA2C4B1C2E3}"/>
              </a:ext>
            </a:extLst>
          </p:cNvPr>
          <p:cNvSpPr/>
          <p:nvPr/>
        </p:nvSpPr>
        <p:spPr>
          <a:xfrm>
            <a:off x="3865958" y="5110807"/>
            <a:ext cx="3180862" cy="288327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44428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23</TotalTime>
  <Words>1012</Words>
  <Application>Microsoft Macintosh PowerPoint</Application>
  <PresentationFormat>Widescreen</PresentationFormat>
  <Paragraphs>190</Paragraphs>
  <Slides>6</Slides>
  <Notes>6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맑은 고딕</vt:lpstr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yuhwan Kwack</dc:creator>
  <cp:lastModifiedBy>Keith Kirkwood</cp:lastModifiedBy>
  <cp:revision>17</cp:revision>
  <dcterms:created xsi:type="dcterms:W3CDTF">2022-07-11T19:57:28Z</dcterms:created>
  <dcterms:modified xsi:type="dcterms:W3CDTF">2022-09-13T12:00:33Z</dcterms:modified>
</cp:coreProperties>
</file>